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7" r:id="rId5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ÍA LÓPEZ MARTÍN" initials="MLM" lastIdx="9" clrIdx="0">
    <p:extLst>
      <p:ext uri="{19B8F6BF-5375-455C-9EA6-DF929625EA0E}">
        <p15:presenceInfo xmlns:p15="http://schemas.microsoft.com/office/powerpoint/2012/main" userId="MARÍA LÓPEZ MARTÍ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53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ÍA LÓPEZ MARTÍN" userId="cf1e4680-9dd8-4ba4-a45e-b8ab3bce13b1" providerId="ADAL" clId="{B4F2F008-0E27-444E-8070-A19CF8E9B3F2}"/>
    <pc:docChg chg="undo custSel modSld">
      <pc:chgData name="MARÍA LÓPEZ MARTÍN" userId="cf1e4680-9dd8-4ba4-a45e-b8ab3bce13b1" providerId="ADAL" clId="{B4F2F008-0E27-444E-8070-A19CF8E9B3F2}" dt="2022-01-17T10:00:07.336" v="114" actId="1035"/>
      <pc:docMkLst>
        <pc:docMk/>
      </pc:docMkLst>
      <pc:sldChg chg="addSp delSp modSp">
        <pc:chgData name="MARÍA LÓPEZ MARTÍN" userId="cf1e4680-9dd8-4ba4-a45e-b8ab3bce13b1" providerId="ADAL" clId="{B4F2F008-0E27-444E-8070-A19CF8E9B3F2}" dt="2022-01-17T10:00:07.336" v="114" actId="1035"/>
        <pc:sldMkLst>
          <pc:docMk/>
          <pc:sldMk cId="1699108906" sldId="257"/>
        </pc:sldMkLst>
        <pc:spChg chg="mod">
          <ac:chgData name="MARÍA LÓPEZ MARTÍN" userId="cf1e4680-9dd8-4ba4-a45e-b8ab3bce13b1" providerId="ADAL" clId="{B4F2F008-0E27-444E-8070-A19CF8E9B3F2}" dt="2022-01-17T10:00:07.336" v="114" actId="1035"/>
          <ac:spMkLst>
            <pc:docMk/>
            <pc:sldMk cId="1699108906" sldId="257"/>
            <ac:spMk id="2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4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23" creationId="{ADD112AE-21EA-4370-BE1D-65F000DB727F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24" creationId="{650E8E67-5F27-4738-A264-2E64C91E71CB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26" creationId="{9858A10C-F653-4433-95BE-FB5364DB960C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29" creationId="{94274419-1BF5-4548-B636-C6164EF1F801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0" creationId="{2BF29D2F-8CB3-404C-BA69-2F0370A27D85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2" creationId="{24970755-B3A3-4C41-B32A-3E86734990A3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3" creationId="{D3368789-5638-4DAA-A66E-5DC7A4B9EA98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4" creationId="{757E876A-6413-40B4-A4F9-0874417B0BCD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5" creationId="{8AF6574A-3A13-4FB4-88C7-73EC3E80A919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7" creationId="{19055846-0701-47F1-9816-4FA105CA2BF6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39" creationId="{E6FCFE75-265F-4A8D-9E8D-EC584047A135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40" creationId="{672C6AC9-37FE-4C3C-A2A1-8A70890D93C8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41" creationId="{0DEA7241-7A08-490A-85C1-F73D6EA55F3C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42" creationId="{138EA4D4-B414-414E-A471-C509DEA8BFF9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46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50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57" creationId="{DAA24D51-6F53-4C7C-864B-FC359636323B}"/>
          </ac:spMkLst>
        </pc:spChg>
        <pc:spChg chg="del">
          <ac:chgData name="MARÍA LÓPEZ MARTÍN" userId="cf1e4680-9dd8-4ba4-a45e-b8ab3bce13b1" providerId="ADAL" clId="{B4F2F008-0E27-444E-8070-A19CF8E9B3F2}" dt="2022-01-17T07:59:11.155" v="27" actId="478"/>
          <ac:spMkLst>
            <pc:docMk/>
            <pc:sldMk cId="1699108906" sldId="257"/>
            <ac:spMk id="58" creationId="{5D4192A7-FBD1-4842-9DF1-68082F6CE498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59" creationId="{DAA24D51-6F53-4C7C-864B-FC359636323B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1" creationId="{3106F949-5D3B-4255-B49A-65739CFA3704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2" creationId="{8AF6574A-3A13-4FB4-88C7-73EC3E80A919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3" creationId="{94274419-1BF5-4548-B636-C6164EF1F801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6" creationId="{DAA24D51-6F53-4C7C-864B-FC359636323B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8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69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0" creationId="{00000000-0000-0000-0000-000000000000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1" creationId="{B84D4C45-025D-40B5-8B7D-B63D4AAFBECA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2" creationId="{69F40A8D-5EA9-4386-8C28-0BEC584FBAA8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3" creationId="{C200B533-00C5-4F0F-A37C-91852DD06502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4" creationId="{16162643-1DFD-4242-AC2C-93F871E2AA21}"/>
          </ac:spMkLst>
        </pc:spChg>
        <pc:spChg chg="add 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5" creationId="{2A428423-3C89-4F07-BA09-8A6F1DA1B925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6" creationId="{C760B871-5CE1-45A8-BADC-E8D16821D233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7" creationId="{2C55D044-4703-4E1C-B15B-44A584D98832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8" creationId="{5318B15F-BFB9-4C28-B815-F3E76B7CE596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79" creationId="{12203941-5DDB-4F0B-A15D-54A9F2D5C1E6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1" creationId="{DA3FC789-2490-4E24-ABBD-D712C33EDC56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2" creationId="{323D253E-86A4-49D1-B7E8-232D384AD085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3" creationId="{A343B6C4-9EB5-4495-BFA0-BE05369297DD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4" creationId="{B3C9D605-3988-4F06-9C4C-9E18947B0AA6}"/>
          </ac:spMkLst>
        </pc:spChg>
        <pc:spChg chg="add 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5" creationId="{7833987B-4AEE-4951-A7B5-8CD1440228D1}"/>
          </ac:spMkLst>
        </pc:spChg>
        <pc:spChg chg="add del mod">
          <ac:chgData name="MARÍA LÓPEZ MARTÍN" userId="cf1e4680-9dd8-4ba4-a45e-b8ab3bce13b1" providerId="ADAL" clId="{B4F2F008-0E27-444E-8070-A19CF8E9B3F2}" dt="2022-01-17T07:59:07.485" v="26" actId="478"/>
          <ac:spMkLst>
            <pc:docMk/>
            <pc:sldMk cId="1699108906" sldId="257"/>
            <ac:spMk id="87" creationId="{A2484BC7-536A-4D09-9446-06B49C798ABF}"/>
          </ac:spMkLst>
        </pc:spChg>
        <pc:spChg chg="add 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8" creationId="{49E6E2D2-D86F-4964-860D-C5E8D8BF4EDB}"/>
          </ac:spMkLst>
        </pc:spChg>
        <pc:spChg chg="add 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89" creationId="{CFA4F4DB-CAF5-4695-86E2-56D7C965580A}"/>
          </ac:spMkLst>
        </pc:spChg>
        <pc:spChg chg="add 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1" creationId="{1E8AB4CD-45F5-40E3-98AF-3A6582ED512D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2" creationId="{02840678-0E52-4BEA-9610-948B0F01D762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3" creationId="{A9C8F47B-8693-419D-AEDF-CDB740F18336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7" creationId="{6082FD54-906A-4519-8D20-FD1845E0CC21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8" creationId="{96821BB5-7A89-437B-9D0E-745759AFC0CB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99" creationId="{7D352742-5EFE-43B4-90CE-0C21ED6F8DE8}"/>
          </ac:spMkLst>
        </pc:spChg>
        <pc:spChg chg="del">
          <ac:chgData name="MARÍA LÓPEZ MARTÍN" userId="cf1e4680-9dd8-4ba4-a45e-b8ab3bce13b1" providerId="ADAL" clId="{B4F2F008-0E27-444E-8070-A19CF8E9B3F2}" dt="2022-01-17T08:34:46.633" v="61" actId="478"/>
          <ac:spMkLst>
            <pc:docMk/>
            <pc:sldMk cId="1699108906" sldId="257"/>
            <ac:spMk id="100" creationId="{3AAB9A29-D6E7-49D7-880D-B2A78327E31E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102" creationId="{5A74EA5B-D70C-4ADB-A759-AA65C46BF65D}"/>
          </ac:spMkLst>
        </pc:spChg>
        <pc:spChg chg="del">
          <ac:chgData name="MARÍA LÓPEZ MARTÍN" userId="cf1e4680-9dd8-4ba4-a45e-b8ab3bce13b1" providerId="ADAL" clId="{B4F2F008-0E27-444E-8070-A19CF8E9B3F2}" dt="2022-01-17T08:34:50.369" v="62" actId="478"/>
          <ac:spMkLst>
            <pc:docMk/>
            <pc:sldMk cId="1699108906" sldId="257"/>
            <ac:spMk id="104" creationId="{2BFA7F16-E014-4021-AA54-4F89828A0F9E}"/>
          </ac:spMkLst>
        </pc:spChg>
        <pc:spChg chg="del">
          <ac:chgData name="MARÍA LÓPEZ MARTÍN" userId="cf1e4680-9dd8-4ba4-a45e-b8ab3bce13b1" providerId="ADAL" clId="{B4F2F008-0E27-444E-8070-A19CF8E9B3F2}" dt="2022-01-17T08:34:52.593" v="63" actId="478"/>
          <ac:spMkLst>
            <pc:docMk/>
            <pc:sldMk cId="1699108906" sldId="257"/>
            <ac:spMk id="105" creationId="{44A472FA-9C2A-41B3-97C9-83F9462BB25E}"/>
          </ac:spMkLst>
        </pc:spChg>
        <pc:spChg chg="mod">
          <ac:chgData name="MARÍA LÓPEZ MARTÍN" userId="cf1e4680-9dd8-4ba4-a45e-b8ab3bce13b1" providerId="ADAL" clId="{B4F2F008-0E27-444E-8070-A19CF8E9B3F2}" dt="2022-01-17T09:59:47.740" v="108" actId="1035"/>
          <ac:spMkLst>
            <pc:docMk/>
            <pc:sldMk cId="1699108906" sldId="257"/>
            <ac:spMk id="106" creationId="{8590173A-EF39-4CE3-A470-2A4A39591580}"/>
          </ac:spMkLst>
        </pc:spChg>
        <pc:grpChg chg="mod">
          <ac:chgData name="MARÍA LÓPEZ MARTÍN" userId="cf1e4680-9dd8-4ba4-a45e-b8ab3bce13b1" providerId="ADAL" clId="{B4F2F008-0E27-444E-8070-A19CF8E9B3F2}" dt="2022-01-17T09:59:47.740" v="108" actId="1035"/>
          <ac:grpSpMkLst>
            <pc:docMk/>
            <pc:sldMk cId="1699108906" sldId="257"/>
            <ac:grpSpMk id="5" creationId="{9DFF1B23-ACE9-4811-8B4E-41212F9D68AE}"/>
          </ac:grpSpMkLst>
        </pc:grp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22" creationId="{4C651EF2-42EE-416B-AA34-01AB1FE53DF2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25" creationId="{71BF5310-2FD7-4E46-ADE7-3E7A7DB25CEA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28" creationId="{A763C906-EC75-48FC-AD4A-A5D5CD9D9F68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31" creationId="{BB10F0EE-2C41-4638-ADC9-1E06AEF75E4B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80" creationId="{83F4011D-AC66-468E-8AE9-6971DA2D3663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86" creationId="{DAC8CB7F-F136-4BAC-94D6-E4DB8E0A9BBA}"/>
          </ac:cxnSpMkLst>
        </pc:cxnChg>
        <pc:cxnChg chg="add 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90" creationId="{F0FAA84F-B47B-4D12-BD59-B5069BA3BBD6}"/>
          </ac:cxnSpMkLst>
        </pc:cxnChg>
        <pc:cxnChg chg="mod">
          <ac:chgData name="MARÍA LÓPEZ MARTÍN" userId="cf1e4680-9dd8-4ba4-a45e-b8ab3bce13b1" providerId="ADAL" clId="{B4F2F008-0E27-444E-8070-A19CF8E9B3F2}" dt="2022-01-17T09:59:47.740" v="108" actId="1035"/>
          <ac:cxnSpMkLst>
            <pc:docMk/>
            <pc:sldMk cId="1699108906" sldId="257"/>
            <ac:cxnSpMk id="96" creationId="{5D0E9808-0826-47AF-8796-BF1152D226EA}"/>
          </ac:cxnSpMkLst>
        </pc:cxnChg>
      </pc:sldChg>
    </pc:docChg>
  </pc:docChgLst>
  <pc:docChgLst>
    <pc:chgData name="MARÍA LÓPEZ MARTÍN" userId="cf1e4680-9dd8-4ba4-a45e-b8ab3bce13b1" providerId="ADAL" clId="{52C4D0AF-5841-4EAC-B85B-59080145DCC8}"/>
    <pc:docChg chg="undo custSel modSld">
      <pc:chgData name="MARÍA LÓPEZ MARTÍN" userId="cf1e4680-9dd8-4ba4-a45e-b8ab3bce13b1" providerId="ADAL" clId="{52C4D0AF-5841-4EAC-B85B-59080145DCC8}" dt="2021-11-08T08:05:31.961" v="543" actId="14100"/>
      <pc:docMkLst>
        <pc:docMk/>
      </pc:docMkLst>
      <pc:sldChg chg="addSp delSp modSp delCm">
        <pc:chgData name="MARÍA LÓPEZ MARTÍN" userId="cf1e4680-9dd8-4ba4-a45e-b8ab3bce13b1" providerId="ADAL" clId="{52C4D0AF-5841-4EAC-B85B-59080145DCC8}" dt="2021-11-08T08:05:31.961" v="543" actId="14100"/>
        <pc:sldMkLst>
          <pc:docMk/>
          <pc:sldMk cId="1699108906" sldId="257"/>
        </pc:sldMkLst>
        <pc:spChg chg="mod">
          <ac:chgData name="MARÍA LÓPEZ MARTÍN" userId="cf1e4680-9dd8-4ba4-a45e-b8ab3bce13b1" providerId="ADAL" clId="{52C4D0AF-5841-4EAC-B85B-59080145DCC8}" dt="2021-11-08T07:56:04.725" v="400" actId="14100"/>
          <ac:spMkLst>
            <pc:docMk/>
            <pc:sldMk cId="1699108906" sldId="257"/>
            <ac:spMk id="4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8:00:15.691" v="447" actId="20577"/>
          <ac:spMkLst>
            <pc:docMk/>
            <pc:sldMk cId="1699108906" sldId="257"/>
            <ac:spMk id="6" creationId="{5D4192A7-FBD1-4842-9DF1-68082F6CE498}"/>
          </ac:spMkLst>
        </pc:spChg>
        <pc:spChg chg="mod topLvl">
          <ac:chgData name="MARÍA LÓPEZ MARTÍN" userId="cf1e4680-9dd8-4ba4-a45e-b8ab3bce13b1" providerId="ADAL" clId="{52C4D0AF-5841-4EAC-B85B-59080145DCC8}" dt="2021-11-08T07:28:06.137" v="79" actId="165"/>
          <ac:spMkLst>
            <pc:docMk/>
            <pc:sldMk cId="1699108906" sldId="257"/>
            <ac:spMk id="23" creationId="{ADD112AE-21EA-4370-BE1D-65F000DB727F}"/>
          </ac:spMkLst>
        </pc:spChg>
        <pc:spChg chg="mod topLvl">
          <ac:chgData name="MARÍA LÓPEZ MARTÍN" userId="cf1e4680-9dd8-4ba4-a45e-b8ab3bce13b1" providerId="ADAL" clId="{52C4D0AF-5841-4EAC-B85B-59080145DCC8}" dt="2021-11-08T07:29:18.803" v="91" actId="12789"/>
          <ac:spMkLst>
            <pc:docMk/>
            <pc:sldMk cId="1699108906" sldId="257"/>
            <ac:spMk id="24" creationId="{650E8E67-5F27-4738-A264-2E64C91E71CB}"/>
          </ac:spMkLst>
        </pc:spChg>
        <pc:spChg chg="mod topLvl">
          <ac:chgData name="MARÍA LÓPEZ MARTÍN" userId="cf1e4680-9dd8-4ba4-a45e-b8ab3bce13b1" providerId="ADAL" clId="{52C4D0AF-5841-4EAC-B85B-59080145DCC8}" dt="2021-11-08T07:28:06.137" v="79" actId="165"/>
          <ac:spMkLst>
            <pc:docMk/>
            <pc:sldMk cId="1699108906" sldId="257"/>
            <ac:spMk id="26" creationId="{9858A10C-F653-4433-95BE-FB5364DB960C}"/>
          </ac:spMkLst>
        </pc:spChg>
        <pc:spChg chg="mod topLvl">
          <ac:chgData name="MARÍA LÓPEZ MARTÍN" userId="cf1e4680-9dd8-4ba4-a45e-b8ab3bce13b1" providerId="ADAL" clId="{52C4D0AF-5841-4EAC-B85B-59080145DCC8}" dt="2021-11-08T07:36:24.339" v="139" actId="1076"/>
          <ac:spMkLst>
            <pc:docMk/>
            <pc:sldMk cId="1699108906" sldId="257"/>
            <ac:spMk id="29" creationId="{94274419-1BF5-4548-B636-C6164EF1F801}"/>
          </ac:spMkLst>
        </pc:spChg>
        <pc:spChg chg="mod topLvl">
          <ac:chgData name="MARÍA LÓPEZ MARTÍN" userId="cf1e4680-9dd8-4ba4-a45e-b8ab3bce13b1" providerId="ADAL" clId="{52C4D0AF-5841-4EAC-B85B-59080145DCC8}" dt="2021-11-08T07:48:51.314" v="328" actId="1037"/>
          <ac:spMkLst>
            <pc:docMk/>
            <pc:sldMk cId="1699108906" sldId="257"/>
            <ac:spMk id="30" creationId="{2BF29D2F-8CB3-404C-BA69-2F0370A27D85}"/>
          </ac:spMkLst>
        </pc:spChg>
        <pc:spChg chg="mod topLvl">
          <ac:chgData name="MARÍA LÓPEZ MARTÍN" userId="cf1e4680-9dd8-4ba4-a45e-b8ab3bce13b1" providerId="ADAL" clId="{52C4D0AF-5841-4EAC-B85B-59080145DCC8}" dt="2021-11-08T07:34:47.068" v="136" actId="1076"/>
          <ac:spMkLst>
            <pc:docMk/>
            <pc:sldMk cId="1699108906" sldId="257"/>
            <ac:spMk id="32" creationId="{24970755-B3A3-4C41-B32A-3E86734990A3}"/>
          </ac:spMkLst>
        </pc:spChg>
        <pc:spChg chg="mod topLvl">
          <ac:chgData name="MARÍA LÓPEZ MARTÍN" userId="cf1e4680-9dd8-4ba4-a45e-b8ab3bce13b1" providerId="ADAL" clId="{52C4D0AF-5841-4EAC-B85B-59080145DCC8}" dt="2021-11-08T07:29:18.803" v="91" actId="12789"/>
          <ac:spMkLst>
            <pc:docMk/>
            <pc:sldMk cId="1699108906" sldId="257"/>
            <ac:spMk id="33" creationId="{D3368789-5638-4DAA-A66E-5DC7A4B9EA98}"/>
          </ac:spMkLst>
        </pc:spChg>
        <pc:spChg chg="mod topLvl">
          <ac:chgData name="MARÍA LÓPEZ MARTÍN" userId="cf1e4680-9dd8-4ba4-a45e-b8ab3bce13b1" providerId="ADAL" clId="{52C4D0AF-5841-4EAC-B85B-59080145DCC8}" dt="2021-11-08T07:28:41.543" v="83" actId="554"/>
          <ac:spMkLst>
            <pc:docMk/>
            <pc:sldMk cId="1699108906" sldId="257"/>
            <ac:spMk id="34" creationId="{757E876A-6413-40B4-A4F9-0874417B0BCD}"/>
          </ac:spMkLst>
        </pc:spChg>
        <pc:spChg chg="mod topLvl">
          <ac:chgData name="MARÍA LÓPEZ MARTÍN" userId="cf1e4680-9dd8-4ba4-a45e-b8ab3bce13b1" providerId="ADAL" clId="{52C4D0AF-5841-4EAC-B85B-59080145DCC8}" dt="2021-11-08T07:28:32.655" v="82" actId="165"/>
          <ac:spMkLst>
            <pc:docMk/>
            <pc:sldMk cId="1699108906" sldId="257"/>
            <ac:spMk id="35" creationId="{8AF6574A-3A13-4FB4-88C7-73EC3E80A919}"/>
          </ac:spMkLst>
        </pc:spChg>
        <pc:spChg chg="mod topLvl">
          <ac:chgData name="MARÍA LÓPEZ MARTÍN" userId="cf1e4680-9dd8-4ba4-a45e-b8ab3bce13b1" providerId="ADAL" clId="{52C4D0AF-5841-4EAC-B85B-59080145DCC8}" dt="2021-11-08T08:00:06.870" v="441" actId="1076"/>
          <ac:spMkLst>
            <pc:docMk/>
            <pc:sldMk cId="1699108906" sldId="257"/>
            <ac:spMk id="37" creationId="{19055846-0701-47F1-9816-4FA105CA2BF6}"/>
          </ac:spMkLst>
        </pc:spChg>
        <pc:spChg chg="mod topLvl">
          <ac:chgData name="MARÍA LÓPEZ MARTÍN" userId="cf1e4680-9dd8-4ba4-a45e-b8ab3bce13b1" providerId="ADAL" clId="{52C4D0AF-5841-4EAC-B85B-59080145DCC8}" dt="2021-11-08T08:01:07.787" v="477" actId="1076"/>
          <ac:spMkLst>
            <pc:docMk/>
            <pc:sldMk cId="1699108906" sldId="257"/>
            <ac:spMk id="39" creationId="{E6FCFE75-265F-4A8D-9E8D-EC584047A135}"/>
          </ac:spMkLst>
        </pc:spChg>
        <pc:spChg chg="mod topLvl">
          <ac:chgData name="MARÍA LÓPEZ MARTÍN" userId="cf1e4680-9dd8-4ba4-a45e-b8ab3bce13b1" providerId="ADAL" clId="{52C4D0AF-5841-4EAC-B85B-59080145DCC8}" dt="2021-11-08T07:48:51.314" v="328" actId="1037"/>
          <ac:spMkLst>
            <pc:docMk/>
            <pc:sldMk cId="1699108906" sldId="257"/>
            <ac:spMk id="40" creationId="{672C6AC9-37FE-4C3C-A2A1-8A70890D93C8}"/>
          </ac:spMkLst>
        </pc:spChg>
        <pc:spChg chg="mod topLvl">
          <ac:chgData name="MARÍA LÓPEZ MARTÍN" userId="cf1e4680-9dd8-4ba4-a45e-b8ab3bce13b1" providerId="ADAL" clId="{52C4D0AF-5841-4EAC-B85B-59080145DCC8}" dt="2021-11-08T07:48:45.620" v="326" actId="1037"/>
          <ac:spMkLst>
            <pc:docMk/>
            <pc:sldMk cId="1699108906" sldId="257"/>
            <ac:spMk id="41" creationId="{0DEA7241-7A08-490A-85C1-F73D6EA55F3C}"/>
          </ac:spMkLst>
        </pc:spChg>
        <pc:spChg chg="mod topLvl">
          <ac:chgData name="MARÍA LÓPEZ MARTÍN" userId="cf1e4680-9dd8-4ba4-a45e-b8ab3bce13b1" providerId="ADAL" clId="{52C4D0AF-5841-4EAC-B85B-59080145DCC8}" dt="2021-11-08T07:48:25.097" v="313" actId="1037"/>
          <ac:spMkLst>
            <pc:docMk/>
            <pc:sldMk cId="1699108906" sldId="257"/>
            <ac:spMk id="42" creationId="{138EA4D4-B414-414E-A471-C509DEA8BFF9}"/>
          </ac:spMkLst>
        </pc:spChg>
        <pc:spChg chg="mod">
          <ac:chgData name="MARÍA LÓPEZ MARTÍN" userId="cf1e4680-9dd8-4ba4-a45e-b8ab3bce13b1" providerId="ADAL" clId="{52C4D0AF-5841-4EAC-B85B-59080145DCC8}" dt="2021-11-08T07:29:38.972" v="92" actId="688"/>
          <ac:spMkLst>
            <pc:docMk/>
            <pc:sldMk cId="1699108906" sldId="257"/>
            <ac:spMk id="46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8:05:24.285" v="542" actId="552"/>
          <ac:spMkLst>
            <pc:docMk/>
            <pc:sldMk cId="1699108906" sldId="257"/>
            <ac:spMk id="50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7:56:09.011" v="407" actId="1036"/>
          <ac:spMkLst>
            <pc:docMk/>
            <pc:sldMk cId="1699108906" sldId="257"/>
            <ac:spMk id="57" creationId="{DAA24D51-6F53-4C7C-864B-FC359636323B}"/>
          </ac:spMkLst>
        </pc:spChg>
        <pc:spChg chg="mod">
          <ac:chgData name="MARÍA LÓPEZ MARTÍN" userId="cf1e4680-9dd8-4ba4-a45e-b8ab3bce13b1" providerId="ADAL" clId="{52C4D0AF-5841-4EAC-B85B-59080145DCC8}" dt="2021-11-08T08:00:22.772" v="453" actId="20577"/>
          <ac:spMkLst>
            <pc:docMk/>
            <pc:sldMk cId="1699108906" sldId="257"/>
            <ac:spMk id="58" creationId="{5D4192A7-FBD1-4842-9DF1-68082F6CE498}"/>
          </ac:spMkLst>
        </pc:spChg>
        <pc:spChg chg="mod">
          <ac:chgData name="MARÍA LÓPEZ MARTÍN" userId="cf1e4680-9dd8-4ba4-a45e-b8ab3bce13b1" providerId="ADAL" clId="{52C4D0AF-5841-4EAC-B85B-59080145DCC8}" dt="2021-11-08T07:30:04.084" v="103" actId="14100"/>
          <ac:spMkLst>
            <pc:docMk/>
            <pc:sldMk cId="1699108906" sldId="257"/>
            <ac:spMk id="59" creationId="{DAA24D51-6F53-4C7C-864B-FC359636323B}"/>
          </ac:spMkLst>
        </pc:spChg>
        <pc:spChg chg="del mod">
          <ac:chgData name="MARÍA LÓPEZ MARTÍN" userId="cf1e4680-9dd8-4ba4-a45e-b8ab3bce13b1" providerId="ADAL" clId="{52C4D0AF-5841-4EAC-B85B-59080145DCC8}" dt="2021-11-08T07:47:49.669" v="302"/>
          <ac:spMkLst>
            <pc:docMk/>
            <pc:sldMk cId="1699108906" sldId="257"/>
            <ac:spMk id="60" creationId="{94274419-1BF5-4548-B636-C6164EF1F801}"/>
          </ac:spMkLst>
        </pc:spChg>
        <pc:spChg chg="add mod">
          <ac:chgData name="MARÍA LÓPEZ MARTÍN" userId="cf1e4680-9dd8-4ba4-a45e-b8ab3bce13b1" providerId="ADAL" clId="{52C4D0AF-5841-4EAC-B85B-59080145DCC8}" dt="2021-11-08T07:25:00.203" v="8" actId="14100"/>
          <ac:spMkLst>
            <pc:docMk/>
            <pc:sldMk cId="1699108906" sldId="257"/>
            <ac:spMk id="61" creationId="{3106F949-5D3B-4255-B49A-65739CFA3704}"/>
          </ac:spMkLst>
        </pc:spChg>
        <pc:spChg chg="mod">
          <ac:chgData name="MARÍA LÓPEZ MARTÍN" userId="cf1e4680-9dd8-4ba4-a45e-b8ab3bce13b1" providerId="ADAL" clId="{52C4D0AF-5841-4EAC-B85B-59080145DCC8}" dt="2021-11-08T07:37:56.990" v="149" actId="1076"/>
          <ac:spMkLst>
            <pc:docMk/>
            <pc:sldMk cId="1699108906" sldId="257"/>
            <ac:spMk id="62" creationId="{8AF6574A-3A13-4FB4-88C7-73EC3E80A919}"/>
          </ac:spMkLst>
        </pc:spChg>
        <pc:spChg chg="mod">
          <ac:chgData name="MARÍA LÓPEZ MARTÍN" userId="cf1e4680-9dd8-4ba4-a45e-b8ab3bce13b1" providerId="ADAL" clId="{52C4D0AF-5841-4EAC-B85B-59080145DCC8}" dt="2021-11-08T07:38:18.881" v="153" actId="1076"/>
          <ac:spMkLst>
            <pc:docMk/>
            <pc:sldMk cId="1699108906" sldId="257"/>
            <ac:spMk id="63" creationId="{94274419-1BF5-4548-B636-C6164EF1F801}"/>
          </ac:spMkLst>
        </pc:spChg>
        <pc:spChg chg="del">
          <ac:chgData name="MARÍA LÓPEZ MARTÍN" userId="cf1e4680-9dd8-4ba4-a45e-b8ab3bce13b1" providerId="ADAL" clId="{52C4D0AF-5841-4EAC-B85B-59080145DCC8}" dt="2021-11-08T07:47:47.546" v="299" actId="478"/>
          <ac:spMkLst>
            <pc:docMk/>
            <pc:sldMk cId="1699108906" sldId="257"/>
            <ac:spMk id="64" creationId="{8AF6574A-3A13-4FB4-88C7-73EC3E80A919}"/>
          </ac:spMkLst>
        </pc:spChg>
        <pc:spChg chg="del mod">
          <ac:chgData name="MARÍA LÓPEZ MARTÍN" userId="cf1e4680-9dd8-4ba4-a45e-b8ab3bce13b1" providerId="ADAL" clId="{52C4D0AF-5841-4EAC-B85B-59080145DCC8}" dt="2021-11-08T07:47:45.148" v="297" actId="478"/>
          <ac:spMkLst>
            <pc:docMk/>
            <pc:sldMk cId="1699108906" sldId="257"/>
            <ac:spMk id="65" creationId="{DAA24D51-6F53-4C7C-864B-FC359636323B}"/>
          </ac:spMkLst>
        </pc:spChg>
        <pc:spChg chg="mod">
          <ac:chgData name="MARÍA LÓPEZ MARTÍN" userId="cf1e4680-9dd8-4ba4-a45e-b8ab3bce13b1" providerId="ADAL" clId="{52C4D0AF-5841-4EAC-B85B-59080145DCC8}" dt="2021-11-08T07:46:36.486" v="287" actId="1037"/>
          <ac:spMkLst>
            <pc:docMk/>
            <pc:sldMk cId="1699108906" sldId="257"/>
            <ac:spMk id="66" creationId="{DAA24D51-6F53-4C7C-864B-FC359636323B}"/>
          </ac:spMkLst>
        </pc:spChg>
        <pc:spChg chg="del mod">
          <ac:chgData name="MARÍA LÓPEZ MARTÍN" userId="cf1e4680-9dd8-4ba4-a45e-b8ab3bce13b1" providerId="ADAL" clId="{52C4D0AF-5841-4EAC-B85B-59080145DCC8}" dt="2021-11-08T07:47:46.196" v="298" actId="478"/>
          <ac:spMkLst>
            <pc:docMk/>
            <pc:sldMk cId="1699108906" sldId="257"/>
            <ac:spMk id="67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8:05:24.285" v="542" actId="552"/>
          <ac:spMkLst>
            <pc:docMk/>
            <pc:sldMk cId="1699108906" sldId="257"/>
            <ac:spMk id="68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8:05:24.285" v="542" actId="552"/>
          <ac:spMkLst>
            <pc:docMk/>
            <pc:sldMk cId="1699108906" sldId="257"/>
            <ac:spMk id="69" creationId="{00000000-0000-0000-0000-000000000000}"/>
          </ac:spMkLst>
        </pc:spChg>
        <pc:spChg chg="mod">
          <ac:chgData name="MARÍA LÓPEZ MARTÍN" userId="cf1e4680-9dd8-4ba4-a45e-b8ab3bce13b1" providerId="ADAL" clId="{52C4D0AF-5841-4EAC-B85B-59080145DCC8}" dt="2021-11-08T08:05:24.285" v="542" actId="552"/>
          <ac:spMkLst>
            <pc:docMk/>
            <pc:sldMk cId="1699108906" sldId="257"/>
            <ac:spMk id="70" creationId="{00000000-0000-0000-0000-000000000000}"/>
          </ac:spMkLst>
        </pc:spChg>
        <pc:spChg chg="add mod">
          <ac:chgData name="MARÍA LÓPEZ MARTÍN" userId="cf1e4680-9dd8-4ba4-a45e-b8ab3bce13b1" providerId="ADAL" clId="{52C4D0AF-5841-4EAC-B85B-59080145DCC8}" dt="2021-11-08T07:25:15.582" v="10" actId="1076"/>
          <ac:spMkLst>
            <pc:docMk/>
            <pc:sldMk cId="1699108906" sldId="257"/>
            <ac:spMk id="71" creationId="{B84D4C45-025D-40B5-8B7D-B63D4AAFBECA}"/>
          </ac:spMkLst>
        </pc:spChg>
        <pc:spChg chg="add mod">
          <ac:chgData name="MARÍA LÓPEZ MARTÍN" userId="cf1e4680-9dd8-4ba4-a45e-b8ab3bce13b1" providerId="ADAL" clId="{52C4D0AF-5841-4EAC-B85B-59080145DCC8}" dt="2021-11-08T07:44:58.527" v="266" actId="14100"/>
          <ac:spMkLst>
            <pc:docMk/>
            <pc:sldMk cId="1699108906" sldId="257"/>
            <ac:spMk id="72" creationId="{69F40A8D-5EA9-4386-8C28-0BEC584FBAA8}"/>
          </ac:spMkLst>
        </pc:spChg>
        <pc:spChg chg="add mod">
          <ac:chgData name="MARÍA LÓPEZ MARTÍN" userId="cf1e4680-9dd8-4ba4-a45e-b8ab3bce13b1" providerId="ADAL" clId="{52C4D0AF-5841-4EAC-B85B-59080145DCC8}" dt="2021-11-08T07:45:01.844" v="268" actId="14100"/>
          <ac:spMkLst>
            <pc:docMk/>
            <pc:sldMk cId="1699108906" sldId="257"/>
            <ac:spMk id="73" creationId="{C200B533-00C5-4F0F-A37C-91852DD06502}"/>
          </ac:spMkLst>
        </pc:spChg>
        <pc:spChg chg="add mod">
          <ac:chgData name="MARÍA LÓPEZ MARTÍN" userId="cf1e4680-9dd8-4ba4-a45e-b8ab3bce13b1" providerId="ADAL" clId="{52C4D0AF-5841-4EAC-B85B-59080145DCC8}" dt="2021-11-08T07:45:04.378" v="269" actId="14100"/>
          <ac:spMkLst>
            <pc:docMk/>
            <pc:sldMk cId="1699108906" sldId="257"/>
            <ac:spMk id="74" creationId="{16162643-1DFD-4242-AC2C-93F871E2AA21}"/>
          </ac:spMkLst>
        </pc:spChg>
        <pc:spChg chg="add mod">
          <ac:chgData name="MARÍA LÓPEZ MARTÍN" userId="cf1e4680-9dd8-4ba4-a45e-b8ab3bce13b1" providerId="ADAL" clId="{52C4D0AF-5841-4EAC-B85B-59080145DCC8}" dt="2021-11-08T07:33:10.565" v="105" actId="1076"/>
          <ac:spMkLst>
            <pc:docMk/>
            <pc:sldMk cId="1699108906" sldId="257"/>
            <ac:spMk id="76" creationId="{C760B871-5CE1-45A8-BADC-E8D16821D233}"/>
          </ac:spMkLst>
        </pc:spChg>
        <pc:spChg chg="add mod">
          <ac:chgData name="MARÍA LÓPEZ MARTÍN" userId="cf1e4680-9dd8-4ba4-a45e-b8ab3bce13b1" providerId="ADAL" clId="{52C4D0AF-5841-4EAC-B85B-59080145DCC8}" dt="2021-11-08T07:34:12.386" v="130" actId="14100"/>
          <ac:spMkLst>
            <pc:docMk/>
            <pc:sldMk cId="1699108906" sldId="257"/>
            <ac:spMk id="77" creationId="{2C55D044-4703-4E1C-B15B-44A584D98832}"/>
          </ac:spMkLst>
        </pc:spChg>
        <pc:spChg chg="add mod">
          <ac:chgData name="MARÍA LÓPEZ MARTÍN" userId="cf1e4680-9dd8-4ba4-a45e-b8ab3bce13b1" providerId="ADAL" clId="{52C4D0AF-5841-4EAC-B85B-59080145DCC8}" dt="2021-11-08T07:37:06.627" v="147" actId="1076"/>
          <ac:spMkLst>
            <pc:docMk/>
            <pc:sldMk cId="1699108906" sldId="257"/>
            <ac:spMk id="78" creationId="{5318B15F-BFB9-4C28-B815-F3E76B7CE596}"/>
          </ac:spMkLst>
        </pc:spChg>
        <pc:spChg chg="add mod">
          <ac:chgData name="MARÍA LÓPEZ MARTÍN" userId="cf1e4680-9dd8-4ba4-a45e-b8ab3bce13b1" providerId="ADAL" clId="{52C4D0AF-5841-4EAC-B85B-59080145DCC8}" dt="2021-11-08T07:34:06.225" v="128" actId="14100"/>
          <ac:spMkLst>
            <pc:docMk/>
            <pc:sldMk cId="1699108906" sldId="257"/>
            <ac:spMk id="79" creationId="{12203941-5DDB-4F0B-A15D-54A9F2D5C1E6}"/>
          </ac:spMkLst>
        </pc:spChg>
        <pc:spChg chg="add mod">
          <ac:chgData name="MARÍA LÓPEZ MARTÍN" userId="cf1e4680-9dd8-4ba4-a45e-b8ab3bce13b1" providerId="ADAL" clId="{52C4D0AF-5841-4EAC-B85B-59080145DCC8}" dt="2021-11-08T08:05:31.961" v="543" actId="14100"/>
          <ac:spMkLst>
            <pc:docMk/>
            <pc:sldMk cId="1699108906" sldId="257"/>
            <ac:spMk id="81" creationId="{DA3FC789-2490-4E24-ABBD-D712C33EDC56}"/>
          </ac:spMkLst>
        </pc:spChg>
        <pc:spChg chg="add mod">
          <ac:chgData name="MARÍA LÓPEZ MARTÍN" userId="cf1e4680-9dd8-4ba4-a45e-b8ab3bce13b1" providerId="ADAL" clId="{52C4D0AF-5841-4EAC-B85B-59080145DCC8}" dt="2021-11-08T07:46:36.486" v="287" actId="1037"/>
          <ac:spMkLst>
            <pc:docMk/>
            <pc:sldMk cId="1699108906" sldId="257"/>
            <ac:spMk id="82" creationId="{323D253E-86A4-49D1-B7E8-232D384AD085}"/>
          </ac:spMkLst>
        </pc:spChg>
        <pc:spChg chg="add mod">
          <ac:chgData name="MARÍA LÓPEZ MARTÍN" userId="cf1e4680-9dd8-4ba4-a45e-b8ab3bce13b1" providerId="ADAL" clId="{52C4D0AF-5841-4EAC-B85B-59080145DCC8}" dt="2021-11-08T07:46:36.486" v="287" actId="1037"/>
          <ac:spMkLst>
            <pc:docMk/>
            <pc:sldMk cId="1699108906" sldId="257"/>
            <ac:spMk id="83" creationId="{A343B6C4-9EB5-4495-BFA0-BE05369297DD}"/>
          </ac:spMkLst>
        </pc:spChg>
        <pc:spChg chg="add mod">
          <ac:chgData name="MARÍA LÓPEZ MARTÍN" userId="cf1e4680-9dd8-4ba4-a45e-b8ab3bce13b1" providerId="ADAL" clId="{52C4D0AF-5841-4EAC-B85B-59080145DCC8}" dt="2021-11-08T07:46:36.486" v="287" actId="1037"/>
          <ac:spMkLst>
            <pc:docMk/>
            <pc:sldMk cId="1699108906" sldId="257"/>
            <ac:spMk id="84" creationId="{B3C9D605-3988-4F06-9C4C-9E18947B0AA6}"/>
          </ac:spMkLst>
        </pc:spChg>
        <pc:spChg chg="add del mod">
          <ac:chgData name="MARÍA LÓPEZ MARTÍN" userId="cf1e4680-9dd8-4ba4-a45e-b8ab3bce13b1" providerId="ADAL" clId="{52C4D0AF-5841-4EAC-B85B-59080145DCC8}" dt="2021-11-08T07:58:38.604" v="423" actId="478"/>
          <ac:spMkLst>
            <pc:docMk/>
            <pc:sldMk cId="1699108906" sldId="257"/>
            <ac:spMk id="88" creationId="{D11052AC-C6E1-42DF-A635-2A1538FBA183}"/>
          </ac:spMkLst>
        </pc:spChg>
        <pc:spChg chg="add del mod">
          <ac:chgData name="MARÍA LÓPEZ MARTÍN" userId="cf1e4680-9dd8-4ba4-a45e-b8ab3bce13b1" providerId="ADAL" clId="{52C4D0AF-5841-4EAC-B85B-59080145DCC8}" dt="2021-11-08T07:58:34.833" v="421" actId="478"/>
          <ac:spMkLst>
            <pc:docMk/>
            <pc:sldMk cId="1699108906" sldId="257"/>
            <ac:spMk id="89" creationId="{BDD16B01-1605-4BF0-BAE9-934AF1818C0E}"/>
          </ac:spMkLst>
        </pc:spChg>
        <pc:spChg chg="add mod">
          <ac:chgData name="MARÍA LÓPEZ MARTÍN" userId="cf1e4680-9dd8-4ba4-a45e-b8ab3bce13b1" providerId="ADAL" clId="{52C4D0AF-5841-4EAC-B85B-59080145DCC8}" dt="2021-11-08T07:50:09.114" v="348" actId="1076"/>
          <ac:spMkLst>
            <pc:docMk/>
            <pc:sldMk cId="1699108906" sldId="257"/>
            <ac:spMk id="92" creationId="{02840678-0E52-4BEA-9610-948B0F01D762}"/>
          </ac:spMkLst>
        </pc:spChg>
        <pc:spChg chg="add mod">
          <ac:chgData name="MARÍA LÓPEZ MARTÍN" userId="cf1e4680-9dd8-4ba4-a45e-b8ab3bce13b1" providerId="ADAL" clId="{52C4D0AF-5841-4EAC-B85B-59080145DCC8}" dt="2021-11-08T07:49:59.845" v="347" actId="20577"/>
          <ac:spMkLst>
            <pc:docMk/>
            <pc:sldMk cId="1699108906" sldId="257"/>
            <ac:spMk id="93" creationId="{A9C8F47B-8693-419D-AEDF-CDB740F18336}"/>
          </ac:spMkLst>
        </pc:spChg>
        <pc:spChg chg="add mod">
          <ac:chgData name="MARÍA LÓPEZ MARTÍN" userId="cf1e4680-9dd8-4ba4-a45e-b8ab3bce13b1" providerId="ADAL" clId="{52C4D0AF-5841-4EAC-B85B-59080145DCC8}" dt="2021-11-08T08:04:09.478" v="539" actId="1037"/>
          <ac:spMkLst>
            <pc:docMk/>
            <pc:sldMk cId="1699108906" sldId="257"/>
            <ac:spMk id="97" creationId="{6082FD54-906A-4519-8D20-FD1845E0CC21}"/>
          </ac:spMkLst>
        </pc:spChg>
        <pc:spChg chg="add mod">
          <ac:chgData name="MARÍA LÓPEZ MARTÍN" userId="cf1e4680-9dd8-4ba4-a45e-b8ab3bce13b1" providerId="ADAL" clId="{52C4D0AF-5841-4EAC-B85B-59080145DCC8}" dt="2021-11-08T07:55:11.113" v="391" actId="1038"/>
          <ac:spMkLst>
            <pc:docMk/>
            <pc:sldMk cId="1699108906" sldId="257"/>
            <ac:spMk id="98" creationId="{96821BB5-7A89-437B-9D0E-745759AFC0CB}"/>
          </ac:spMkLst>
        </pc:spChg>
        <pc:spChg chg="add mod">
          <ac:chgData name="MARÍA LÓPEZ MARTÍN" userId="cf1e4680-9dd8-4ba4-a45e-b8ab3bce13b1" providerId="ADAL" clId="{52C4D0AF-5841-4EAC-B85B-59080145DCC8}" dt="2021-11-08T08:01:16.663" v="479" actId="1076"/>
          <ac:spMkLst>
            <pc:docMk/>
            <pc:sldMk cId="1699108906" sldId="257"/>
            <ac:spMk id="99" creationId="{7D352742-5EFE-43B4-90CE-0C21ED6F8DE8}"/>
          </ac:spMkLst>
        </pc:spChg>
        <pc:spChg chg="add mod">
          <ac:chgData name="MARÍA LÓPEZ MARTÍN" userId="cf1e4680-9dd8-4ba4-a45e-b8ab3bce13b1" providerId="ADAL" clId="{52C4D0AF-5841-4EAC-B85B-59080145DCC8}" dt="2021-11-08T07:56:21.014" v="409" actId="1076"/>
          <ac:spMkLst>
            <pc:docMk/>
            <pc:sldMk cId="1699108906" sldId="257"/>
            <ac:spMk id="100" creationId="{3AAB9A29-D6E7-49D7-880D-B2A78327E31E}"/>
          </ac:spMkLst>
        </pc:spChg>
        <pc:spChg chg="add del mod">
          <ac:chgData name="MARÍA LÓPEZ MARTÍN" userId="cf1e4680-9dd8-4ba4-a45e-b8ab3bce13b1" providerId="ADAL" clId="{52C4D0AF-5841-4EAC-B85B-59080145DCC8}" dt="2021-11-08T07:57:17.396" v="412" actId="478"/>
          <ac:spMkLst>
            <pc:docMk/>
            <pc:sldMk cId="1699108906" sldId="257"/>
            <ac:spMk id="101" creationId="{0C6BFDD6-49FD-40C8-8138-219501B84E43}"/>
          </ac:spMkLst>
        </pc:spChg>
        <pc:spChg chg="add mod">
          <ac:chgData name="MARÍA LÓPEZ MARTÍN" userId="cf1e4680-9dd8-4ba4-a45e-b8ab3bce13b1" providerId="ADAL" clId="{52C4D0AF-5841-4EAC-B85B-59080145DCC8}" dt="2021-11-08T07:57:48.241" v="420" actId="20577"/>
          <ac:spMkLst>
            <pc:docMk/>
            <pc:sldMk cId="1699108906" sldId="257"/>
            <ac:spMk id="102" creationId="{5A74EA5B-D70C-4ADB-A759-AA65C46BF65D}"/>
          </ac:spMkLst>
        </pc:spChg>
        <pc:spChg chg="add mod">
          <ac:chgData name="MARÍA LÓPEZ MARTÍN" userId="cf1e4680-9dd8-4ba4-a45e-b8ab3bce13b1" providerId="ADAL" clId="{52C4D0AF-5841-4EAC-B85B-59080145DCC8}" dt="2021-11-08T08:01:58.297" v="491" actId="1076"/>
          <ac:spMkLst>
            <pc:docMk/>
            <pc:sldMk cId="1699108906" sldId="257"/>
            <ac:spMk id="104" creationId="{2BFA7F16-E014-4021-AA54-4F89828A0F9E}"/>
          </ac:spMkLst>
        </pc:spChg>
        <pc:spChg chg="add mod">
          <ac:chgData name="MARÍA LÓPEZ MARTÍN" userId="cf1e4680-9dd8-4ba4-a45e-b8ab3bce13b1" providerId="ADAL" clId="{52C4D0AF-5841-4EAC-B85B-59080145DCC8}" dt="2021-11-08T08:02:50.881" v="528" actId="1076"/>
          <ac:spMkLst>
            <pc:docMk/>
            <pc:sldMk cId="1699108906" sldId="257"/>
            <ac:spMk id="105" creationId="{44A472FA-9C2A-41B3-97C9-83F9462BB25E}"/>
          </ac:spMkLst>
        </pc:spChg>
        <pc:spChg chg="add mod">
          <ac:chgData name="MARÍA LÓPEZ MARTÍN" userId="cf1e4680-9dd8-4ba4-a45e-b8ab3bce13b1" providerId="ADAL" clId="{52C4D0AF-5841-4EAC-B85B-59080145DCC8}" dt="2021-11-08T08:04:09.478" v="539" actId="1037"/>
          <ac:spMkLst>
            <pc:docMk/>
            <pc:sldMk cId="1699108906" sldId="257"/>
            <ac:spMk id="106" creationId="{8590173A-EF39-4CE3-A470-2A4A39591580}"/>
          </ac:spMkLst>
        </pc:spChg>
        <pc:grpChg chg="mod topLvl">
          <ac:chgData name="MARÍA LÓPEZ MARTÍN" userId="cf1e4680-9dd8-4ba4-a45e-b8ab3bce13b1" providerId="ADAL" clId="{52C4D0AF-5841-4EAC-B85B-59080145DCC8}" dt="2021-11-08T07:27:43.885" v="75" actId="165"/>
          <ac:grpSpMkLst>
            <pc:docMk/>
            <pc:sldMk cId="1699108906" sldId="257"/>
            <ac:grpSpMk id="5" creationId="{9DFF1B23-ACE9-4811-8B4E-41212F9D68AE}"/>
          </ac:grpSpMkLst>
        </pc:grpChg>
        <pc:grpChg chg="del mod topLvl">
          <ac:chgData name="MARÍA LÓPEZ MARTÍN" userId="cf1e4680-9dd8-4ba4-a45e-b8ab3bce13b1" providerId="ADAL" clId="{52C4D0AF-5841-4EAC-B85B-59080145DCC8}" dt="2021-11-08T07:28:06.137" v="79" actId="165"/>
          <ac:grpSpMkLst>
            <pc:docMk/>
            <pc:sldMk cId="1699108906" sldId="257"/>
            <ac:grpSpMk id="21" creationId="{00000000-0000-0000-0000-000000000000}"/>
          </ac:grpSpMkLst>
        </pc:grpChg>
        <pc:grpChg chg="del mod topLvl">
          <ac:chgData name="MARÍA LÓPEZ MARTÍN" userId="cf1e4680-9dd8-4ba4-a45e-b8ab3bce13b1" providerId="ADAL" clId="{52C4D0AF-5841-4EAC-B85B-59080145DCC8}" dt="2021-11-08T07:28:32.655" v="82" actId="165"/>
          <ac:grpSpMkLst>
            <pc:docMk/>
            <pc:sldMk cId="1699108906" sldId="257"/>
            <ac:grpSpMk id="27" creationId="{00000000-0000-0000-0000-000000000000}"/>
          </ac:grpSpMkLst>
        </pc:grpChg>
        <pc:grpChg chg="del mod topLvl">
          <ac:chgData name="MARÍA LÓPEZ MARTÍN" userId="cf1e4680-9dd8-4ba4-a45e-b8ab3bce13b1" providerId="ADAL" clId="{52C4D0AF-5841-4EAC-B85B-59080145DCC8}" dt="2021-11-08T07:36:38.932" v="140" actId="165"/>
          <ac:grpSpMkLst>
            <pc:docMk/>
            <pc:sldMk cId="1699108906" sldId="257"/>
            <ac:grpSpMk id="36" creationId="{00000000-0000-0000-0000-000000000000}"/>
          </ac:grpSpMkLst>
        </pc:grpChg>
        <pc:grpChg chg="del mod">
          <ac:chgData name="MARÍA LÓPEZ MARTÍN" userId="cf1e4680-9dd8-4ba4-a45e-b8ab3bce13b1" providerId="ADAL" clId="{52C4D0AF-5841-4EAC-B85B-59080145DCC8}" dt="2021-11-08T07:27:43.885" v="75" actId="165"/>
          <ac:grpSpMkLst>
            <pc:docMk/>
            <pc:sldMk cId="1699108906" sldId="257"/>
            <ac:grpSpMk id="44" creationId="{00000000-0000-0000-0000-000000000000}"/>
          </ac:grpSpMkLst>
        </pc:grpChg>
        <pc:picChg chg="del mod">
          <ac:chgData name="MARÍA LÓPEZ MARTÍN" userId="cf1e4680-9dd8-4ba4-a45e-b8ab3bce13b1" providerId="ADAL" clId="{52C4D0AF-5841-4EAC-B85B-59080145DCC8}" dt="2021-11-08T07:34:31.893" v="135" actId="478"/>
          <ac:picMkLst>
            <pc:docMk/>
            <pc:sldMk cId="1699108906" sldId="257"/>
            <ac:picMk id="1026" creationId="{00000000-0000-0000-0000-000000000000}"/>
          </ac:picMkLst>
        </pc:picChg>
        <pc:cxnChg chg="mod topLvl">
          <ac:chgData name="MARÍA LÓPEZ MARTÍN" userId="cf1e4680-9dd8-4ba4-a45e-b8ab3bce13b1" providerId="ADAL" clId="{52C4D0AF-5841-4EAC-B85B-59080145DCC8}" dt="2021-11-08T07:28:06.137" v="79" actId="165"/>
          <ac:cxnSpMkLst>
            <pc:docMk/>
            <pc:sldMk cId="1699108906" sldId="257"/>
            <ac:cxnSpMk id="22" creationId="{4C651EF2-42EE-416B-AA34-01AB1FE53DF2}"/>
          </ac:cxnSpMkLst>
        </pc:cxnChg>
        <pc:cxnChg chg="add del mod topLvl">
          <ac:chgData name="MARÍA LÓPEZ MARTÍN" userId="cf1e4680-9dd8-4ba4-a45e-b8ab3bce13b1" providerId="ADAL" clId="{52C4D0AF-5841-4EAC-B85B-59080145DCC8}" dt="2021-11-08T07:28:58.990" v="88" actId="1076"/>
          <ac:cxnSpMkLst>
            <pc:docMk/>
            <pc:sldMk cId="1699108906" sldId="257"/>
            <ac:cxnSpMk id="25" creationId="{71BF5310-2FD7-4E46-ADE7-3E7A7DB25CEA}"/>
          </ac:cxnSpMkLst>
        </pc:cxnChg>
        <pc:cxnChg chg="mod topLvl">
          <ac:chgData name="MARÍA LÓPEZ MARTÍN" userId="cf1e4680-9dd8-4ba4-a45e-b8ab3bce13b1" providerId="ADAL" clId="{52C4D0AF-5841-4EAC-B85B-59080145DCC8}" dt="2021-11-08T07:47:03.933" v="291" actId="1076"/>
          <ac:cxnSpMkLst>
            <pc:docMk/>
            <pc:sldMk cId="1699108906" sldId="257"/>
            <ac:cxnSpMk id="28" creationId="{A763C906-EC75-48FC-AD4A-A5D5CD9D9F68}"/>
          </ac:cxnSpMkLst>
        </pc:cxnChg>
        <pc:cxnChg chg="mod topLvl">
          <ac:chgData name="MARÍA LÓPEZ MARTÍN" userId="cf1e4680-9dd8-4ba4-a45e-b8ab3bce13b1" providerId="ADAL" clId="{52C4D0AF-5841-4EAC-B85B-59080145DCC8}" dt="2021-11-08T07:48:57.603" v="329" actId="14100"/>
          <ac:cxnSpMkLst>
            <pc:docMk/>
            <pc:sldMk cId="1699108906" sldId="257"/>
            <ac:cxnSpMk id="31" creationId="{BB10F0EE-2C41-4638-ADC9-1E06AEF75E4B}"/>
          </ac:cxnSpMkLst>
        </pc:cxnChg>
        <pc:cxnChg chg="del mod topLvl">
          <ac:chgData name="MARÍA LÓPEZ MARTÍN" userId="cf1e4680-9dd8-4ba4-a45e-b8ab3bce13b1" providerId="ADAL" clId="{52C4D0AF-5841-4EAC-B85B-59080145DCC8}" dt="2021-11-08T07:47:02.329" v="290" actId="478"/>
          <ac:cxnSpMkLst>
            <pc:docMk/>
            <pc:sldMk cId="1699108906" sldId="257"/>
            <ac:cxnSpMk id="38" creationId="{C4AF0382-8A32-47D5-9048-5D57263FA1AF}"/>
          </ac:cxnSpMkLst>
        </pc:cxnChg>
        <pc:cxnChg chg="add del">
          <ac:chgData name="MARÍA LÓPEZ MARTÍN" userId="cf1e4680-9dd8-4ba4-a45e-b8ab3bce13b1" providerId="ADAL" clId="{52C4D0AF-5841-4EAC-B85B-59080145DCC8}" dt="2021-11-08T07:28:53.019" v="87"/>
          <ac:cxnSpMkLst>
            <pc:docMk/>
            <pc:sldMk cId="1699108906" sldId="257"/>
            <ac:cxnSpMk id="75" creationId="{B0356740-E1BC-465D-BD7C-99C50287F78A}"/>
          </ac:cxnSpMkLst>
        </pc:cxnChg>
        <pc:cxnChg chg="add mod">
          <ac:chgData name="MARÍA LÓPEZ MARTÍN" userId="cf1e4680-9dd8-4ba4-a45e-b8ab3bce13b1" providerId="ADAL" clId="{52C4D0AF-5841-4EAC-B85B-59080145DCC8}" dt="2021-11-08T07:41:34.761" v="228" actId="14100"/>
          <ac:cxnSpMkLst>
            <pc:docMk/>
            <pc:sldMk cId="1699108906" sldId="257"/>
            <ac:cxnSpMk id="80" creationId="{83F4011D-AC66-468E-8AE9-6971DA2D3663}"/>
          </ac:cxnSpMkLst>
        </pc:cxnChg>
        <pc:cxnChg chg="add del mod">
          <ac:chgData name="MARÍA LÓPEZ MARTÍN" userId="cf1e4680-9dd8-4ba4-a45e-b8ab3bce13b1" providerId="ADAL" clId="{52C4D0AF-5841-4EAC-B85B-59080145DCC8}" dt="2021-11-08T07:47:51.132" v="303" actId="478"/>
          <ac:cxnSpMkLst>
            <pc:docMk/>
            <pc:sldMk cId="1699108906" sldId="257"/>
            <ac:cxnSpMk id="85" creationId="{4A3DD028-D533-46A4-BC48-DE292A24713E}"/>
          </ac:cxnSpMkLst>
        </pc:cxnChg>
        <pc:cxnChg chg="add mod">
          <ac:chgData name="MARÍA LÓPEZ MARTÍN" userId="cf1e4680-9dd8-4ba4-a45e-b8ab3bce13b1" providerId="ADAL" clId="{52C4D0AF-5841-4EAC-B85B-59080145DCC8}" dt="2021-11-08T07:59:51.714" v="432" actId="14100"/>
          <ac:cxnSpMkLst>
            <pc:docMk/>
            <pc:sldMk cId="1699108906" sldId="257"/>
            <ac:cxnSpMk id="86" creationId="{DAC8CB7F-F136-4BAC-94D6-E4DB8E0A9BBA}"/>
          </ac:cxnSpMkLst>
        </pc:cxnChg>
        <pc:cxnChg chg="add del mod">
          <ac:chgData name="MARÍA LÓPEZ MARTÍN" userId="cf1e4680-9dd8-4ba4-a45e-b8ab3bce13b1" providerId="ADAL" clId="{52C4D0AF-5841-4EAC-B85B-59080145DCC8}" dt="2021-11-08T07:58:36.803" v="422" actId="478"/>
          <ac:cxnSpMkLst>
            <pc:docMk/>
            <pc:sldMk cId="1699108906" sldId="257"/>
            <ac:cxnSpMk id="90" creationId="{AEF4A5F0-B674-46EC-AB14-812331EAEB3F}"/>
          </ac:cxnSpMkLst>
        </pc:cxnChg>
        <pc:cxnChg chg="add del mod">
          <ac:chgData name="MARÍA LÓPEZ MARTÍN" userId="cf1e4680-9dd8-4ba4-a45e-b8ab3bce13b1" providerId="ADAL" clId="{52C4D0AF-5841-4EAC-B85B-59080145DCC8}" dt="2021-11-08T07:50:11.323" v="349" actId="478"/>
          <ac:cxnSpMkLst>
            <pc:docMk/>
            <pc:sldMk cId="1699108906" sldId="257"/>
            <ac:cxnSpMk id="94" creationId="{91E3BE6E-4F30-4E29-94D1-A329DAA26063}"/>
          </ac:cxnSpMkLst>
        </pc:cxnChg>
        <pc:cxnChg chg="add mod">
          <ac:chgData name="MARÍA LÓPEZ MARTÍN" userId="cf1e4680-9dd8-4ba4-a45e-b8ab3bce13b1" providerId="ADAL" clId="{52C4D0AF-5841-4EAC-B85B-59080145DCC8}" dt="2021-11-08T07:50:19.076" v="351" actId="1076"/>
          <ac:cxnSpMkLst>
            <pc:docMk/>
            <pc:sldMk cId="1699108906" sldId="257"/>
            <ac:cxnSpMk id="96" creationId="{5D0E9808-0826-47AF-8796-BF1152D226EA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1F85BD-901A-4AA9-8A92-9956861FAF6A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75E51D-CD51-47E5-AD49-DC69E50940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1230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322072-2A47-4041-95DF-F4691BC75BFA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10492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1575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7857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257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7639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772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4477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5042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77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4736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8672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9489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FD58D-6139-42EC-B1FB-2108F019386D}" type="datetimeFigureOut">
              <a:rPr lang="es-ES" smtClean="0"/>
              <a:t>05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521722-C494-40AA-B63E-36839B2F980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4682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069157" y="-99392"/>
            <a:ext cx="6599187" cy="424600"/>
          </a:xfrm>
        </p:spPr>
        <p:txBody>
          <a:bodyPr>
            <a:noAutofit/>
          </a:bodyPr>
          <a:lstStyle/>
          <a:p>
            <a:r>
              <a:rPr lang="es-ES" sz="1800" b="1" dirty="0"/>
              <a:t>Plant material </a:t>
            </a:r>
            <a:r>
              <a:rPr lang="es-ES" sz="1800" b="1" dirty="0" err="1"/>
              <a:t>generated</a:t>
            </a:r>
            <a:r>
              <a:rPr lang="es-ES" sz="1800" b="1" dirty="0"/>
              <a:t> and </a:t>
            </a:r>
            <a:r>
              <a:rPr lang="es-ES" sz="1800" b="1" dirty="0" err="1"/>
              <a:t>methodology</a:t>
            </a:r>
            <a:r>
              <a:rPr lang="es-ES" sz="1800" b="1" dirty="0"/>
              <a:t> </a:t>
            </a:r>
            <a:r>
              <a:rPr lang="es-ES" sz="1800" b="1" dirty="0" err="1"/>
              <a:t>used</a:t>
            </a:r>
            <a:endParaRPr lang="es-ES" sz="1800" b="1" dirty="0"/>
          </a:p>
        </p:txBody>
      </p:sp>
      <p:grpSp>
        <p:nvGrpSpPr>
          <p:cNvPr id="5" name="Grupo 5">
            <a:extLst>
              <a:ext uri="{FF2B5EF4-FFF2-40B4-BE49-F238E27FC236}">
                <a16:creationId xmlns:a16="http://schemas.microsoft.com/office/drawing/2014/main" id="{9DFF1B23-ACE9-4811-8B4E-41212F9D68AE}"/>
              </a:ext>
            </a:extLst>
          </p:cNvPr>
          <p:cNvGrpSpPr/>
          <p:nvPr/>
        </p:nvGrpSpPr>
        <p:grpSpPr>
          <a:xfrm>
            <a:off x="2574331" y="449288"/>
            <a:ext cx="4223062" cy="2196669"/>
            <a:chOff x="1439654" y="1519340"/>
            <a:chExt cx="3775900" cy="1846991"/>
          </a:xfrm>
        </p:grpSpPr>
        <p:sp>
          <p:nvSpPr>
            <p:cNvPr id="6" name="CuadroTexto 169">
              <a:extLst>
                <a:ext uri="{FF2B5EF4-FFF2-40B4-BE49-F238E27FC236}">
                  <a16:creationId xmlns:a16="http://schemas.microsoft.com/office/drawing/2014/main" id="{5D4192A7-FBD1-4842-9DF1-68082F6CE498}"/>
                </a:ext>
              </a:extLst>
            </p:cNvPr>
            <p:cNvSpPr txBox="1"/>
            <p:nvPr/>
          </p:nvSpPr>
          <p:spPr>
            <a:xfrm>
              <a:off x="1439654" y="3099430"/>
              <a:ext cx="996409" cy="232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/>
                <a:t>200 </a:t>
              </a:r>
              <a:r>
                <a:rPr lang="es-ES" sz="1200" b="1" dirty="0" err="1"/>
                <a:t>plants</a:t>
              </a:r>
              <a:r>
                <a:rPr lang="es-ES" sz="1200" b="1" dirty="0"/>
                <a:t> </a:t>
              </a:r>
            </a:p>
          </p:txBody>
        </p:sp>
        <p:grpSp>
          <p:nvGrpSpPr>
            <p:cNvPr id="7" name="Grupo 3">
              <a:extLst>
                <a:ext uri="{FF2B5EF4-FFF2-40B4-BE49-F238E27FC236}">
                  <a16:creationId xmlns:a16="http://schemas.microsoft.com/office/drawing/2014/main" id="{8B53B853-283E-4500-ADEA-6788C10D36FE}"/>
                </a:ext>
              </a:extLst>
            </p:cNvPr>
            <p:cNvGrpSpPr/>
            <p:nvPr/>
          </p:nvGrpSpPr>
          <p:grpSpPr>
            <a:xfrm>
              <a:off x="1764790" y="1519340"/>
              <a:ext cx="3450764" cy="1846991"/>
              <a:chOff x="1764790" y="1519340"/>
              <a:chExt cx="3450764" cy="1846991"/>
            </a:xfrm>
          </p:grpSpPr>
          <p:grpSp>
            <p:nvGrpSpPr>
              <p:cNvPr id="8" name="Grupo 35">
                <a:extLst>
                  <a:ext uri="{FF2B5EF4-FFF2-40B4-BE49-F238E27FC236}">
                    <a16:creationId xmlns:a16="http://schemas.microsoft.com/office/drawing/2014/main" id="{31E955D1-3B44-407F-BEE7-3EF4842CF581}"/>
                  </a:ext>
                </a:extLst>
              </p:cNvPr>
              <p:cNvGrpSpPr/>
              <p:nvPr/>
            </p:nvGrpSpPr>
            <p:grpSpPr>
              <a:xfrm>
                <a:off x="3007679" y="1523602"/>
                <a:ext cx="298142" cy="489864"/>
                <a:chOff x="3007679" y="1523602"/>
                <a:chExt cx="298142" cy="489864"/>
              </a:xfrm>
            </p:grpSpPr>
            <p:sp>
              <p:nvSpPr>
                <p:cNvPr id="19" name="CuadroTexto 192">
                  <a:extLst>
                    <a:ext uri="{FF2B5EF4-FFF2-40B4-BE49-F238E27FC236}">
                      <a16:creationId xmlns:a16="http://schemas.microsoft.com/office/drawing/2014/main" id="{ACDAFB7C-F992-4090-957F-107117EEAC70}"/>
                    </a:ext>
                  </a:extLst>
                </p:cNvPr>
                <p:cNvSpPr txBox="1"/>
                <p:nvPr/>
              </p:nvSpPr>
              <p:spPr>
                <a:xfrm>
                  <a:off x="3007679" y="1523602"/>
                  <a:ext cx="2981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dirty="0"/>
                    <a:t>X</a:t>
                  </a:r>
                </a:p>
              </p:txBody>
            </p:sp>
            <p:cxnSp>
              <p:nvCxnSpPr>
                <p:cNvPr id="20" name="Conector recto de flecha 193">
                  <a:extLst>
                    <a:ext uri="{FF2B5EF4-FFF2-40B4-BE49-F238E27FC236}">
                      <a16:creationId xmlns:a16="http://schemas.microsoft.com/office/drawing/2014/main" id="{ACDB972D-163E-49D0-A031-292676F776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56661" y="1846562"/>
                  <a:ext cx="89" cy="16690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" name="Grupo 194">
                <a:extLst>
                  <a:ext uri="{FF2B5EF4-FFF2-40B4-BE49-F238E27FC236}">
                    <a16:creationId xmlns:a16="http://schemas.microsoft.com/office/drawing/2014/main" id="{716321F6-E71A-4101-B5D1-DEF45A408819}"/>
                  </a:ext>
                </a:extLst>
              </p:cNvPr>
              <p:cNvGrpSpPr/>
              <p:nvPr/>
            </p:nvGrpSpPr>
            <p:grpSpPr>
              <a:xfrm>
                <a:off x="2959592" y="1957438"/>
                <a:ext cx="772971" cy="957948"/>
                <a:chOff x="3514535" y="1502496"/>
                <a:chExt cx="772971" cy="957948"/>
              </a:xfrm>
            </p:grpSpPr>
            <p:sp>
              <p:nvSpPr>
                <p:cNvPr id="17" name="CuadroTexto 195">
                  <a:extLst>
                    <a:ext uri="{FF2B5EF4-FFF2-40B4-BE49-F238E27FC236}">
                      <a16:creationId xmlns:a16="http://schemas.microsoft.com/office/drawing/2014/main" id="{84DCA847-760F-4563-B59C-1A9481A31781}"/>
                    </a:ext>
                  </a:extLst>
                </p:cNvPr>
                <p:cNvSpPr txBox="1"/>
                <p:nvPr/>
              </p:nvSpPr>
              <p:spPr>
                <a:xfrm>
                  <a:off x="3989364" y="1502496"/>
                  <a:ext cx="2981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dirty="0"/>
                    <a:t>X</a:t>
                  </a:r>
                </a:p>
              </p:txBody>
            </p:sp>
            <p:cxnSp>
              <p:nvCxnSpPr>
                <p:cNvPr id="18" name="Conector recto de flecha 196">
                  <a:extLst>
                    <a:ext uri="{FF2B5EF4-FFF2-40B4-BE49-F238E27FC236}">
                      <a16:creationId xmlns:a16="http://schemas.microsoft.com/office/drawing/2014/main" id="{A5D0081B-CAF0-4856-95B9-81E1D2DFB705}"/>
                    </a:ext>
                  </a:extLst>
                </p:cNvPr>
                <p:cNvCxnSpPr>
                  <a:cxnSpLocks/>
                  <a:stCxn id="17" idx="2"/>
                </p:cNvCxnSpPr>
                <p:nvPr/>
              </p:nvCxnSpPr>
              <p:spPr>
                <a:xfrm flipH="1">
                  <a:off x="3514535" y="1871828"/>
                  <a:ext cx="623901" cy="58861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" name="Conector recto de flecha 197">
                <a:extLst>
                  <a:ext uri="{FF2B5EF4-FFF2-40B4-BE49-F238E27FC236}">
                    <a16:creationId xmlns:a16="http://schemas.microsoft.com/office/drawing/2014/main" id="{8F1DE4BB-E5E8-491D-861E-93DD989247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1156" y="2773748"/>
                <a:ext cx="0" cy="28592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lgDashDot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Rectángulo: esquinas redondeadas 55">
                <a:extLst>
                  <a:ext uri="{FF2B5EF4-FFF2-40B4-BE49-F238E27FC236}">
                    <a16:creationId xmlns:a16="http://schemas.microsoft.com/office/drawing/2014/main" id="{4A9E0623-B3F8-4E50-A253-B40352C4EF3C}"/>
                  </a:ext>
                </a:extLst>
              </p:cNvPr>
              <p:cNvSpPr/>
              <p:nvPr/>
            </p:nvSpPr>
            <p:spPr>
              <a:xfrm>
                <a:off x="1764790" y="1519340"/>
                <a:ext cx="1194801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dirty="0">
                    <a:solidFill>
                      <a:schemeClr val="tx1"/>
                    </a:solidFill>
                  </a:rPr>
                  <a:t>TGR-1551</a:t>
                </a:r>
              </a:p>
            </p:txBody>
          </p:sp>
          <p:sp>
            <p:nvSpPr>
              <p:cNvPr id="12" name="Rectángulo: esquinas redondeadas 56">
                <a:extLst>
                  <a:ext uri="{FF2B5EF4-FFF2-40B4-BE49-F238E27FC236}">
                    <a16:creationId xmlns:a16="http://schemas.microsoft.com/office/drawing/2014/main" id="{030E2433-31CA-4251-88B2-9CA2CFC1C4D0}"/>
                  </a:ext>
                </a:extLst>
              </p:cNvPr>
              <p:cNvSpPr/>
              <p:nvPr/>
            </p:nvSpPr>
            <p:spPr>
              <a:xfrm>
                <a:off x="3353909" y="1519340"/>
                <a:ext cx="1861645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dirty="0">
                    <a:solidFill>
                      <a:schemeClr val="tx1"/>
                    </a:solidFill>
                  </a:rPr>
                  <a:t>Bola de oro (BO)</a:t>
                </a:r>
              </a:p>
            </p:txBody>
          </p:sp>
          <p:sp>
            <p:nvSpPr>
              <p:cNvPr id="13" name="Rectángulo: esquinas redondeadas 57">
                <a:extLst>
                  <a:ext uri="{FF2B5EF4-FFF2-40B4-BE49-F238E27FC236}">
                    <a16:creationId xmlns:a16="http://schemas.microsoft.com/office/drawing/2014/main" id="{09C172BC-92DD-4DEB-A8AD-7E5E822022DB}"/>
                  </a:ext>
                </a:extLst>
              </p:cNvPr>
              <p:cNvSpPr/>
              <p:nvPr/>
            </p:nvSpPr>
            <p:spPr>
              <a:xfrm>
                <a:off x="2878901" y="2011839"/>
                <a:ext cx="555520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dirty="0">
                    <a:solidFill>
                      <a:schemeClr val="tx1"/>
                    </a:solidFill>
                  </a:rPr>
                  <a:t>F1</a:t>
                </a:r>
              </a:p>
            </p:txBody>
          </p:sp>
          <p:sp>
            <p:nvSpPr>
              <p:cNvPr id="14" name="Rectángulo: esquinas redondeadas 58">
                <a:extLst>
                  <a:ext uri="{FF2B5EF4-FFF2-40B4-BE49-F238E27FC236}">
                    <a16:creationId xmlns:a16="http://schemas.microsoft.com/office/drawing/2014/main" id="{33527A47-4859-4DA3-8481-3DF2866D698C}"/>
                  </a:ext>
                </a:extLst>
              </p:cNvPr>
              <p:cNvSpPr/>
              <p:nvPr/>
            </p:nvSpPr>
            <p:spPr>
              <a:xfrm>
                <a:off x="3729211" y="2004322"/>
                <a:ext cx="555520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dirty="0">
                    <a:solidFill>
                      <a:schemeClr val="tx1"/>
                    </a:solidFill>
                  </a:rPr>
                  <a:t>BO</a:t>
                </a:r>
              </a:p>
            </p:txBody>
          </p:sp>
          <p:sp>
            <p:nvSpPr>
              <p:cNvPr id="15" name="Rectángulo: esquinas redondeadas 59">
                <a:extLst>
                  <a:ext uri="{FF2B5EF4-FFF2-40B4-BE49-F238E27FC236}">
                    <a16:creationId xmlns:a16="http://schemas.microsoft.com/office/drawing/2014/main" id="{A7E5482D-0F58-4C6D-A24B-BB1C0BF1FA03}"/>
                  </a:ext>
                </a:extLst>
              </p:cNvPr>
              <p:cNvSpPr/>
              <p:nvPr/>
            </p:nvSpPr>
            <p:spPr>
              <a:xfrm>
                <a:off x="2339543" y="2479341"/>
                <a:ext cx="555520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dirty="0">
                    <a:solidFill>
                      <a:schemeClr val="tx1"/>
                    </a:solidFill>
                  </a:rPr>
                  <a:t>BC</a:t>
                </a:r>
                <a:r>
                  <a:rPr lang="es-ES" baseline="-25000" dirty="0">
                    <a:solidFill>
                      <a:schemeClr val="tx1"/>
                    </a:solidFill>
                  </a:rPr>
                  <a:t>1</a:t>
                </a:r>
              </a:p>
            </p:txBody>
          </p:sp>
          <p:sp>
            <p:nvSpPr>
              <p:cNvPr id="16" name="Rectángulo: esquinas redondeadas 61">
                <a:extLst>
                  <a:ext uri="{FF2B5EF4-FFF2-40B4-BE49-F238E27FC236}">
                    <a16:creationId xmlns:a16="http://schemas.microsoft.com/office/drawing/2014/main" id="{4EBB5D06-A23D-4028-A384-85FEED72EA43}"/>
                  </a:ext>
                </a:extLst>
              </p:cNvPr>
              <p:cNvSpPr/>
              <p:nvPr/>
            </p:nvSpPr>
            <p:spPr>
              <a:xfrm>
                <a:off x="2339543" y="3077267"/>
                <a:ext cx="555520" cy="28906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dirty="0">
                    <a:solidFill>
                      <a:schemeClr val="tx1"/>
                    </a:solidFill>
                  </a:rPr>
                  <a:t>BC</a:t>
                </a:r>
                <a:r>
                  <a:rPr lang="es-ES" baseline="-25000" dirty="0">
                    <a:solidFill>
                      <a:schemeClr val="tx1"/>
                    </a:solidFill>
                  </a:rPr>
                  <a:t>3</a:t>
                </a:r>
              </a:p>
            </p:txBody>
          </p:sp>
        </p:grpSp>
      </p:grpSp>
      <p:cxnSp>
        <p:nvCxnSpPr>
          <p:cNvPr id="22" name="Conector recto de flecha 198">
            <a:extLst>
              <a:ext uri="{FF2B5EF4-FFF2-40B4-BE49-F238E27FC236}">
                <a16:creationId xmlns:a16="http://schemas.microsoft.com/office/drawing/2014/main" id="{4C651EF2-42EE-416B-AA34-01AB1FE53DF2}"/>
              </a:ext>
            </a:extLst>
          </p:cNvPr>
          <p:cNvCxnSpPr>
            <a:cxnSpLocks/>
          </p:cNvCxnSpPr>
          <p:nvPr/>
        </p:nvCxnSpPr>
        <p:spPr>
          <a:xfrm flipH="1">
            <a:off x="3497240" y="2749510"/>
            <a:ext cx="282922" cy="6561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199">
            <a:extLst>
              <a:ext uri="{FF2B5EF4-FFF2-40B4-BE49-F238E27FC236}">
                <a16:creationId xmlns:a16="http://schemas.microsoft.com/office/drawing/2014/main" id="{ADD112AE-21EA-4370-BE1D-65F000DB727F}"/>
              </a:ext>
            </a:extLst>
          </p:cNvPr>
          <p:cNvSpPr txBox="1"/>
          <p:nvPr/>
        </p:nvSpPr>
        <p:spPr>
          <a:xfrm>
            <a:off x="3196215" y="2628909"/>
            <a:ext cx="333449" cy="439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X</a:t>
            </a:r>
          </a:p>
        </p:txBody>
      </p:sp>
      <p:sp>
        <p:nvSpPr>
          <p:cNvPr id="24" name="Diagrama de flujo: unión de suma 200">
            <a:extLst>
              <a:ext uri="{FF2B5EF4-FFF2-40B4-BE49-F238E27FC236}">
                <a16:creationId xmlns:a16="http://schemas.microsoft.com/office/drawing/2014/main" id="{650E8E67-5F27-4738-A264-2E64C91E71CB}"/>
              </a:ext>
            </a:extLst>
          </p:cNvPr>
          <p:cNvSpPr/>
          <p:nvPr/>
        </p:nvSpPr>
        <p:spPr>
          <a:xfrm>
            <a:off x="4368750" y="3133763"/>
            <a:ext cx="245330" cy="253401"/>
          </a:xfrm>
          <a:prstGeom prst="flowChartSummingJunct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25" name="Conector recto 60">
            <a:extLst>
              <a:ext uri="{FF2B5EF4-FFF2-40B4-BE49-F238E27FC236}">
                <a16:creationId xmlns:a16="http://schemas.microsoft.com/office/drawing/2014/main" id="{71BF5310-2FD7-4E46-ADE7-3E7A7DB25CEA}"/>
              </a:ext>
            </a:extLst>
          </p:cNvPr>
          <p:cNvCxnSpPr>
            <a:cxnSpLocks/>
          </p:cNvCxnSpPr>
          <p:nvPr/>
        </p:nvCxnSpPr>
        <p:spPr>
          <a:xfrm>
            <a:off x="3927647" y="2754451"/>
            <a:ext cx="400402" cy="35707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ángulo: esquinas redondeadas 62">
            <a:extLst>
              <a:ext uri="{FF2B5EF4-FFF2-40B4-BE49-F238E27FC236}">
                <a16:creationId xmlns:a16="http://schemas.microsoft.com/office/drawing/2014/main" id="{9858A10C-F653-4433-95BE-FB5364DB960C}"/>
              </a:ext>
            </a:extLst>
          </p:cNvPr>
          <p:cNvSpPr/>
          <p:nvPr/>
        </p:nvSpPr>
        <p:spPr>
          <a:xfrm>
            <a:off x="2485825" y="2767733"/>
            <a:ext cx="621307" cy="343791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BO</a:t>
            </a:r>
          </a:p>
        </p:txBody>
      </p:sp>
      <p:cxnSp>
        <p:nvCxnSpPr>
          <p:cNvPr id="28" name="Conector recto de flecha 202">
            <a:extLst>
              <a:ext uri="{FF2B5EF4-FFF2-40B4-BE49-F238E27FC236}">
                <a16:creationId xmlns:a16="http://schemas.microsoft.com/office/drawing/2014/main" id="{A763C906-EC75-48FC-AD4A-A5D5CD9D9F68}"/>
              </a:ext>
            </a:extLst>
          </p:cNvPr>
          <p:cNvCxnSpPr>
            <a:cxnSpLocks/>
          </p:cNvCxnSpPr>
          <p:nvPr/>
        </p:nvCxnSpPr>
        <p:spPr>
          <a:xfrm>
            <a:off x="3145964" y="3858327"/>
            <a:ext cx="0" cy="7184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uadroTexto 203">
            <a:extLst>
              <a:ext uri="{FF2B5EF4-FFF2-40B4-BE49-F238E27FC236}">
                <a16:creationId xmlns:a16="http://schemas.microsoft.com/office/drawing/2014/main" id="{94274419-1BF5-4548-B636-C6164EF1F801}"/>
              </a:ext>
            </a:extLst>
          </p:cNvPr>
          <p:cNvSpPr txBox="1"/>
          <p:nvPr/>
        </p:nvSpPr>
        <p:spPr>
          <a:xfrm>
            <a:off x="2824488" y="3743077"/>
            <a:ext cx="333449" cy="439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X</a:t>
            </a:r>
          </a:p>
        </p:txBody>
      </p:sp>
      <p:sp>
        <p:nvSpPr>
          <p:cNvPr id="30" name="Diagrama de flujo: unión de suma 204">
            <a:extLst>
              <a:ext uri="{FF2B5EF4-FFF2-40B4-BE49-F238E27FC236}">
                <a16:creationId xmlns:a16="http://schemas.microsoft.com/office/drawing/2014/main" id="{2BF29D2F-8CB3-404C-BA69-2F0370A27D85}"/>
              </a:ext>
            </a:extLst>
          </p:cNvPr>
          <p:cNvSpPr/>
          <p:nvPr/>
        </p:nvSpPr>
        <p:spPr>
          <a:xfrm>
            <a:off x="3606590" y="4262766"/>
            <a:ext cx="245330" cy="253401"/>
          </a:xfrm>
          <a:prstGeom prst="flowChartSummingJunct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1" name="Conector recto 206">
            <a:extLst>
              <a:ext uri="{FF2B5EF4-FFF2-40B4-BE49-F238E27FC236}">
                <a16:creationId xmlns:a16="http://schemas.microsoft.com/office/drawing/2014/main" id="{BB10F0EE-2C41-4638-ADC9-1E06AEF75E4B}"/>
              </a:ext>
            </a:extLst>
          </p:cNvPr>
          <p:cNvCxnSpPr>
            <a:cxnSpLocks/>
            <a:endCxn id="30" idx="0"/>
          </p:cNvCxnSpPr>
          <p:nvPr/>
        </p:nvCxnSpPr>
        <p:spPr>
          <a:xfrm>
            <a:off x="3631980" y="3831766"/>
            <a:ext cx="97275" cy="431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CuadroTexto 217">
            <a:extLst>
              <a:ext uri="{FF2B5EF4-FFF2-40B4-BE49-F238E27FC236}">
                <a16:creationId xmlns:a16="http://schemas.microsoft.com/office/drawing/2014/main" id="{24970755-B3A3-4C41-B32A-3E86734990A3}"/>
              </a:ext>
            </a:extLst>
          </p:cNvPr>
          <p:cNvSpPr txBox="1"/>
          <p:nvPr/>
        </p:nvSpPr>
        <p:spPr>
          <a:xfrm>
            <a:off x="5439762" y="3840323"/>
            <a:ext cx="1114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20 </a:t>
            </a:r>
            <a:r>
              <a:rPr lang="es-ES" sz="1200" b="1" dirty="0" err="1"/>
              <a:t>families</a:t>
            </a:r>
            <a:r>
              <a:rPr lang="es-ES" sz="1200" b="1" dirty="0"/>
              <a:t> </a:t>
            </a:r>
          </a:p>
        </p:txBody>
      </p:sp>
      <p:sp>
        <p:nvSpPr>
          <p:cNvPr id="33" name="Rectángulo: esquinas redondeadas 63">
            <a:extLst>
              <a:ext uri="{FF2B5EF4-FFF2-40B4-BE49-F238E27FC236}">
                <a16:creationId xmlns:a16="http://schemas.microsoft.com/office/drawing/2014/main" id="{D3368789-5638-4DAA-A66E-5DC7A4B9EA98}"/>
              </a:ext>
            </a:extLst>
          </p:cNvPr>
          <p:cNvSpPr/>
          <p:nvPr/>
        </p:nvSpPr>
        <p:spPr>
          <a:xfrm>
            <a:off x="4067723" y="3455150"/>
            <a:ext cx="835197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3</a:t>
            </a:r>
            <a:r>
              <a:rPr lang="es-ES" dirty="0">
                <a:solidFill>
                  <a:schemeClr val="tx1"/>
                </a:solidFill>
              </a:rPr>
              <a:t>S</a:t>
            </a:r>
            <a:r>
              <a:rPr lang="es-ES" baseline="-25000" dirty="0">
                <a:solidFill>
                  <a:schemeClr val="tx1"/>
                </a:solidFill>
              </a:rPr>
              <a:t>1</a:t>
            </a:r>
          </a:p>
        </p:txBody>
      </p:sp>
      <p:sp>
        <p:nvSpPr>
          <p:cNvPr id="34" name="Rectángulo: esquinas redondeadas 65">
            <a:extLst>
              <a:ext uri="{FF2B5EF4-FFF2-40B4-BE49-F238E27FC236}">
                <a16:creationId xmlns:a16="http://schemas.microsoft.com/office/drawing/2014/main" id="{757E876A-6413-40B4-A4F9-0874417B0BCD}"/>
              </a:ext>
            </a:extLst>
          </p:cNvPr>
          <p:cNvSpPr/>
          <p:nvPr/>
        </p:nvSpPr>
        <p:spPr>
          <a:xfrm>
            <a:off x="3037609" y="3455150"/>
            <a:ext cx="621308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4</a:t>
            </a:r>
          </a:p>
        </p:txBody>
      </p:sp>
      <p:sp>
        <p:nvSpPr>
          <p:cNvPr id="35" name="Rectángulo: esquinas redondeadas 94">
            <a:extLst>
              <a:ext uri="{FF2B5EF4-FFF2-40B4-BE49-F238E27FC236}">
                <a16:creationId xmlns:a16="http://schemas.microsoft.com/office/drawing/2014/main" id="{8AF6574A-3A13-4FB4-88C7-73EC3E80A919}"/>
              </a:ext>
            </a:extLst>
          </p:cNvPr>
          <p:cNvSpPr/>
          <p:nvPr/>
        </p:nvSpPr>
        <p:spPr>
          <a:xfrm>
            <a:off x="2292454" y="4045677"/>
            <a:ext cx="621308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BO</a:t>
            </a:r>
          </a:p>
        </p:txBody>
      </p:sp>
      <p:sp>
        <p:nvSpPr>
          <p:cNvPr id="37" name="Diagrama de flujo: unión de suma 210">
            <a:extLst>
              <a:ext uri="{FF2B5EF4-FFF2-40B4-BE49-F238E27FC236}">
                <a16:creationId xmlns:a16="http://schemas.microsoft.com/office/drawing/2014/main" id="{19055846-0701-47F1-9816-4FA105CA2BF6}"/>
              </a:ext>
            </a:extLst>
          </p:cNvPr>
          <p:cNvSpPr/>
          <p:nvPr/>
        </p:nvSpPr>
        <p:spPr>
          <a:xfrm>
            <a:off x="2776818" y="5129808"/>
            <a:ext cx="245330" cy="253401"/>
          </a:xfrm>
          <a:prstGeom prst="flowChartSummingJunct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" name="CuadroTexto 218">
            <a:extLst>
              <a:ext uri="{FF2B5EF4-FFF2-40B4-BE49-F238E27FC236}">
                <a16:creationId xmlns:a16="http://schemas.microsoft.com/office/drawing/2014/main" id="{E6FCFE75-265F-4A8D-9E8D-EC584047A135}"/>
              </a:ext>
            </a:extLst>
          </p:cNvPr>
          <p:cNvSpPr txBox="1"/>
          <p:nvPr/>
        </p:nvSpPr>
        <p:spPr>
          <a:xfrm>
            <a:off x="2512263" y="4886699"/>
            <a:ext cx="799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3 </a:t>
            </a:r>
            <a:r>
              <a:rPr lang="es-ES" sz="1200" b="1" dirty="0" err="1"/>
              <a:t>families</a:t>
            </a:r>
            <a:r>
              <a:rPr lang="es-ES" sz="1200" b="1" dirty="0"/>
              <a:t> </a:t>
            </a:r>
          </a:p>
        </p:txBody>
      </p:sp>
      <p:sp>
        <p:nvSpPr>
          <p:cNvPr id="40" name="Rectángulo: esquinas redondeadas 64">
            <a:extLst>
              <a:ext uri="{FF2B5EF4-FFF2-40B4-BE49-F238E27FC236}">
                <a16:creationId xmlns:a16="http://schemas.microsoft.com/office/drawing/2014/main" id="{672C6AC9-37FE-4C3C-A2A1-8A70890D93C8}"/>
              </a:ext>
            </a:extLst>
          </p:cNvPr>
          <p:cNvSpPr/>
          <p:nvPr/>
        </p:nvSpPr>
        <p:spPr>
          <a:xfrm>
            <a:off x="3347864" y="4571743"/>
            <a:ext cx="742199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4</a:t>
            </a:r>
            <a:r>
              <a:rPr lang="es-ES" dirty="0">
                <a:solidFill>
                  <a:schemeClr val="tx1"/>
                </a:solidFill>
              </a:rPr>
              <a:t>S</a:t>
            </a:r>
            <a:r>
              <a:rPr lang="es-ES" baseline="-25000" dirty="0">
                <a:solidFill>
                  <a:schemeClr val="tx1"/>
                </a:solidFill>
              </a:rPr>
              <a:t>1</a:t>
            </a:r>
          </a:p>
        </p:txBody>
      </p:sp>
      <p:sp>
        <p:nvSpPr>
          <p:cNvPr id="41" name="Rectángulo: esquinas redondeadas 67">
            <a:extLst>
              <a:ext uri="{FF2B5EF4-FFF2-40B4-BE49-F238E27FC236}">
                <a16:creationId xmlns:a16="http://schemas.microsoft.com/office/drawing/2014/main" id="{0DEA7241-7A08-490A-85C1-F73D6EA55F3C}"/>
              </a:ext>
            </a:extLst>
          </p:cNvPr>
          <p:cNvSpPr/>
          <p:nvPr/>
        </p:nvSpPr>
        <p:spPr>
          <a:xfrm>
            <a:off x="2627784" y="4564240"/>
            <a:ext cx="543398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5</a:t>
            </a:r>
          </a:p>
        </p:txBody>
      </p:sp>
      <p:sp>
        <p:nvSpPr>
          <p:cNvPr id="42" name="Rectángulo: esquinas redondeadas 68">
            <a:extLst>
              <a:ext uri="{FF2B5EF4-FFF2-40B4-BE49-F238E27FC236}">
                <a16:creationId xmlns:a16="http://schemas.microsoft.com/office/drawing/2014/main" id="{138EA4D4-B414-414E-A471-C509DEA8BFF9}"/>
              </a:ext>
            </a:extLst>
          </p:cNvPr>
          <p:cNvSpPr/>
          <p:nvPr/>
        </p:nvSpPr>
        <p:spPr>
          <a:xfrm>
            <a:off x="2483768" y="5578106"/>
            <a:ext cx="835197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5</a:t>
            </a:r>
            <a:r>
              <a:rPr lang="es-ES" dirty="0">
                <a:solidFill>
                  <a:schemeClr val="tx1"/>
                </a:solidFill>
              </a:rPr>
              <a:t>S</a:t>
            </a:r>
            <a:r>
              <a:rPr lang="es-ES" baseline="-25000" dirty="0">
                <a:solidFill>
                  <a:schemeClr val="tx1"/>
                </a:solidFill>
              </a:rPr>
              <a:t>1</a:t>
            </a:r>
          </a:p>
        </p:txBody>
      </p:sp>
      <p:sp>
        <p:nvSpPr>
          <p:cNvPr id="4" name="3 Cerrar llave"/>
          <p:cNvSpPr/>
          <p:nvPr/>
        </p:nvSpPr>
        <p:spPr>
          <a:xfrm rot="10800000">
            <a:off x="1907699" y="3295821"/>
            <a:ext cx="229019" cy="3499361"/>
          </a:xfrm>
          <a:prstGeom prst="rightBrac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7" name="Rectángulo: esquinas redondeadas 71">
            <a:extLst>
              <a:ext uri="{FF2B5EF4-FFF2-40B4-BE49-F238E27FC236}">
                <a16:creationId xmlns:a16="http://schemas.microsoft.com/office/drawing/2014/main" id="{DAA24D51-6F53-4C7C-864B-FC359636323B}"/>
              </a:ext>
            </a:extLst>
          </p:cNvPr>
          <p:cNvSpPr/>
          <p:nvPr/>
        </p:nvSpPr>
        <p:spPr>
          <a:xfrm>
            <a:off x="288010" y="4284647"/>
            <a:ext cx="1547686" cy="989177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Inoculation</a:t>
            </a:r>
            <a:endParaRPr lang="es-ES" sz="1400" dirty="0">
              <a:solidFill>
                <a:schemeClr val="tx1"/>
              </a:solidFill>
            </a:endParaRPr>
          </a:p>
          <a:p>
            <a:pPr algn="ctr"/>
            <a:r>
              <a:rPr lang="es-ES" sz="1400" dirty="0" err="1">
                <a:solidFill>
                  <a:schemeClr val="tx1"/>
                </a:solidFill>
              </a:rPr>
              <a:t>Evaluation</a:t>
            </a:r>
            <a:endParaRPr lang="es-ES" sz="1400" dirty="0">
              <a:solidFill>
                <a:schemeClr val="tx1"/>
              </a:solidFill>
            </a:endParaRPr>
          </a:p>
          <a:p>
            <a:pPr algn="ctr"/>
            <a:r>
              <a:rPr lang="es-ES" sz="1400" dirty="0" err="1">
                <a:solidFill>
                  <a:schemeClr val="tx1"/>
                </a:solidFill>
              </a:rPr>
              <a:t>Selection</a:t>
            </a:r>
            <a:endParaRPr lang="es-ES" sz="1400" dirty="0">
              <a:solidFill>
                <a:schemeClr val="tx1"/>
              </a:solidFill>
            </a:endParaRPr>
          </a:p>
          <a:p>
            <a:pPr algn="ctr"/>
            <a:r>
              <a:rPr lang="es-ES" sz="1400" dirty="0" err="1">
                <a:solidFill>
                  <a:schemeClr val="tx1"/>
                </a:solidFill>
              </a:rPr>
              <a:t>Races</a:t>
            </a:r>
            <a:r>
              <a:rPr lang="es-ES" sz="1400" dirty="0">
                <a:solidFill>
                  <a:schemeClr val="tx1"/>
                </a:solidFill>
              </a:rPr>
              <a:t> 1,2 and 5</a:t>
            </a:r>
          </a:p>
        </p:txBody>
      </p:sp>
      <p:sp>
        <p:nvSpPr>
          <p:cNvPr id="59" name="Rectángulo: esquinas redondeadas 71">
            <a:extLst>
              <a:ext uri="{FF2B5EF4-FFF2-40B4-BE49-F238E27FC236}">
                <a16:creationId xmlns:a16="http://schemas.microsoft.com/office/drawing/2014/main" id="{DAA24D51-6F53-4C7C-864B-FC359636323B}"/>
              </a:ext>
            </a:extLst>
          </p:cNvPr>
          <p:cNvSpPr/>
          <p:nvPr/>
        </p:nvSpPr>
        <p:spPr>
          <a:xfrm>
            <a:off x="5334269" y="3435749"/>
            <a:ext cx="1114409" cy="380964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Genotyping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46" name="45 Abrir llave"/>
          <p:cNvSpPr/>
          <p:nvPr/>
        </p:nvSpPr>
        <p:spPr>
          <a:xfrm rot="10800000">
            <a:off x="5045430" y="3202774"/>
            <a:ext cx="246650" cy="846914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Rectángulo: esquinas redondeadas 94">
            <a:extLst>
              <a:ext uri="{FF2B5EF4-FFF2-40B4-BE49-F238E27FC236}">
                <a16:creationId xmlns:a16="http://schemas.microsoft.com/office/drawing/2014/main" id="{8AF6574A-3A13-4FB4-88C7-73EC3E80A919}"/>
              </a:ext>
            </a:extLst>
          </p:cNvPr>
          <p:cNvSpPr/>
          <p:nvPr/>
        </p:nvSpPr>
        <p:spPr>
          <a:xfrm>
            <a:off x="4749915" y="4133821"/>
            <a:ext cx="621308" cy="343791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PS</a:t>
            </a:r>
          </a:p>
        </p:txBody>
      </p:sp>
      <p:sp>
        <p:nvSpPr>
          <p:cNvPr id="63" name="CuadroTexto 203">
            <a:extLst>
              <a:ext uri="{FF2B5EF4-FFF2-40B4-BE49-F238E27FC236}">
                <a16:creationId xmlns:a16="http://schemas.microsoft.com/office/drawing/2014/main" id="{94274419-1BF5-4548-B636-C6164EF1F801}"/>
              </a:ext>
            </a:extLst>
          </p:cNvPr>
          <p:cNvSpPr txBox="1"/>
          <p:nvPr/>
        </p:nvSpPr>
        <p:spPr>
          <a:xfrm>
            <a:off x="4451096" y="4116048"/>
            <a:ext cx="305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X</a:t>
            </a:r>
          </a:p>
        </p:txBody>
      </p:sp>
      <p:sp>
        <p:nvSpPr>
          <p:cNvPr id="66" name="Rectángulo: esquinas redondeadas 71">
            <a:extLst>
              <a:ext uri="{FF2B5EF4-FFF2-40B4-BE49-F238E27FC236}">
                <a16:creationId xmlns:a16="http://schemas.microsoft.com/office/drawing/2014/main" id="{DAA24D51-6F53-4C7C-864B-FC359636323B}"/>
              </a:ext>
            </a:extLst>
          </p:cNvPr>
          <p:cNvSpPr/>
          <p:nvPr/>
        </p:nvSpPr>
        <p:spPr>
          <a:xfrm>
            <a:off x="5436096" y="4560781"/>
            <a:ext cx="1075505" cy="34379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Genotyping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50" name="49 Rectángulo"/>
          <p:cNvSpPr/>
          <p:nvPr/>
        </p:nvSpPr>
        <p:spPr>
          <a:xfrm>
            <a:off x="8118653" y="3405617"/>
            <a:ext cx="648072" cy="3899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2019</a:t>
            </a:r>
          </a:p>
        </p:txBody>
      </p:sp>
      <p:sp>
        <p:nvSpPr>
          <p:cNvPr id="68" name="67 Rectángulo"/>
          <p:cNvSpPr/>
          <p:nvPr/>
        </p:nvSpPr>
        <p:spPr>
          <a:xfrm>
            <a:off x="8118653" y="4571743"/>
            <a:ext cx="648072" cy="3899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2020</a:t>
            </a:r>
          </a:p>
        </p:txBody>
      </p:sp>
      <p:sp>
        <p:nvSpPr>
          <p:cNvPr id="69" name="68 Rectángulo"/>
          <p:cNvSpPr/>
          <p:nvPr/>
        </p:nvSpPr>
        <p:spPr>
          <a:xfrm>
            <a:off x="8435717" y="5899158"/>
            <a:ext cx="648072" cy="3899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2021</a:t>
            </a:r>
          </a:p>
        </p:txBody>
      </p:sp>
      <p:sp>
        <p:nvSpPr>
          <p:cNvPr id="70" name="69 Rectángulo"/>
          <p:cNvSpPr/>
          <p:nvPr/>
        </p:nvSpPr>
        <p:spPr>
          <a:xfrm>
            <a:off x="8118653" y="2279718"/>
            <a:ext cx="648072" cy="3899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2018</a:t>
            </a:r>
          </a:p>
        </p:txBody>
      </p:sp>
      <p:sp>
        <p:nvSpPr>
          <p:cNvPr id="61" name="Rectángulo: esquinas redondeadas 71">
            <a:extLst>
              <a:ext uri="{FF2B5EF4-FFF2-40B4-BE49-F238E27FC236}">
                <a16:creationId xmlns:a16="http://schemas.microsoft.com/office/drawing/2014/main" id="{3106F949-5D3B-4255-B49A-65739CFA3704}"/>
              </a:ext>
            </a:extLst>
          </p:cNvPr>
          <p:cNvSpPr/>
          <p:nvPr/>
        </p:nvSpPr>
        <p:spPr>
          <a:xfrm>
            <a:off x="4644008" y="2294066"/>
            <a:ext cx="1100972" cy="351891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Genotyping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71" name="45 Abrir llave">
            <a:extLst>
              <a:ext uri="{FF2B5EF4-FFF2-40B4-BE49-F238E27FC236}">
                <a16:creationId xmlns:a16="http://schemas.microsoft.com/office/drawing/2014/main" id="{B84D4C45-025D-40B5-8B7D-B63D4AAFBECA}"/>
              </a:ext>
            </a:extLst>
          </p:cNvPr>
          <p:cNvSpPr/>
          <p:nvPr/>
        </p:nvSpPr>
        <p:spPr>
          <a:xfrm>
            <a:off x="5829783" y="1889448"/>
            <a:ext cx="186254" cy="1167546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2" name="Rectángulo: esquinas redondeadas 71">
            <a:extLst>
              <a:ext uri="{FF2B5EF4-FFF2-40B4-BE49-F238E27FC236}">
                <a16:creationId xmlns:a16="http://schemas.microsoft.com/office/drawing/2014/main" id="{69F40A8D-5EA9-4386-8C28-0BEC584FBAA8}"/>
              </a:ext>
            </a:extLst>
          </p:cNvPr>
          <p:cNvSpPr/>
          <p:nvPr/>
        </p:nvSpPr>
        <p:spPr>
          <a:xfrm>
            <a:off x="6114097" y="1923547"/>
            <a:ext cx="1825872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Background</a:t>
            </a:r>
            <a:r>
              <a:rPr lang="es-ES" sz="1400" dirty="0">
                <a:solidFill>
                  <a:schemeClr val="tx1"/>
                </a:solidFill>
              </a:rPr>
              <a:t> </a:t>
            </a:r>
            <a:r>
              <a:rPr lang="es-ES" sz="1400" dirty="0" err="1">
                <a:solidFill>
                  <a:schemeClr val="tx1"/>
                </a:solidFill>
              </a:rPr>
              <a:t>markers</a:t>
            </a:r>
            <a:r>
              <a:rPr lang="es-ES" sz="1400" dirty="0">
                <a:solidFill>
                  <a:schemeClr val="tx1"/>
                </a:solidFill>
              </a:rPr>
              <a:t> 1</a:t>
            </a:r>
          </a:p>
        </p:txBody>
      </p:sp>
      <p:sp>
        <p:nvSpPr>
          <p:cNvPr id="73" name="Rectángulo: esquinas redondeadas 72">
            <a:extLst>
              <a:ext uri="{FF2B5EF4-FFF2-40B4-BE49-F238E27FC236}">
                <a16:creationId xmlns:a16="http://schemas.microsoft.com/office/drawing/2014/main" id="{C200B533-00C5-4F0F-A37C-91852DD06502}"/>
              </a:ext>
            </a:extLst>
          </p:cNvPr>
          <p:cNvSpPr/>
          <p:nvPr/>
        </p:nvSpPr>
        <p:spPr>
          <a:xfrm>
            <a:off x="6109272" y="2216675"/>
            <a:ext cx="1825872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Set CYSDV1</a:t>
            </a:r>
          </a:p>
        </p:txBody>
      </p:sp>
      <p:sp>
        <p:nvSpPr>
          <p:cNvPr id="74" name="Rectángulo: esquinas redondeadas 73">
            <a:extLst>
              <a:ext uri="{FF2B5EF4-FFF2-40B4-BE49-F238E27FC236}">
                <a16:creationId xmlns:a16="http://schemas.microsoft.com/office/drawing/2014/main" id="{16162643-1DFD-4242-AC2C-93F871E2AA21}"/>
              </a:ext>
            </a:extLst>
          </p:cNvPr>
          <p:cNvSpPr/>
          <p:nvPr/>
        </p:nvSpPr>
        <p:spPr>
          <a:xfrm>
            <a:off x="6109272" y="2504707"/>
            <a:ext cx="1825872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Set WMV1</a:t>
            </a:r>
          </a:p>
        </p:txBody>
      </p:sp>
      <p:sp>
        <p:nvSpPr>
          <p:cNvPr id="76" name="45 Abrir llave">
            <a:extLst>
              <a:ext uri="{FF2B5EF4-FFF2-40B4-BE49-F238E27FC236}">
                <a16:creationId xmlns:a16="http://schemas.microsoft.com/office/drawing/2014/main" id="{C760B871-5CE1-45A8-BADC-E8D16821D233}"/>
              </a:ext>
            </a:extLst>
          </p:cNvPr>
          <p:cNvSpPr/>
          <p:nvPr/>
        </p:nvSpPr>
        <p:spPr>
          <a:xfrm>
            <a:off x="6491413" y="3198763"/>
            <a:ext cx="246650" cy="846914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Rectángulo: esquinas redondeadas 76">
            <a:extLst>
              <a:ext uri="{FF2B5EF4-FFF2-40B4-BE49-F238E27FC236}">
                <a16:creationId xmlns:a16="http://schemas.microsoft.com/office/drawing/2014/main" id="{2C55D044-4703-4E1C-B15B-44A584D98832}"/>
              </a:ext>
            </a:extLst>
          </p:cNvPr>
          <p:cNvSpPr/>
          <p:nvPr/>
        </p:nvSpPr>
        <p:spPr>
          <a:xfrm>
            <a:off x="6776303" y="3098066"/>
            <a:ext cx="1199333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Set CYSDV1</a:t>
            </a:r>
          </a:p>
        </p:txBody>
      </p:sp>
      <p:sp>
        <p:nvSpPr>
          <p:cNvPr id="78" name="Rectángulo: esquinas redondeadas 77">
            <a:extLst>
              <a:ext uri="{FF2B5EF4-FFF2-40B4-BE49-F238E27FC236}">
                <a16:creationId xmlns:a16="http://schemas.microsoft.com/office/drawing/2014/main" id="{5318B15F-BFB9-4C28-B815-F3E76B7CE596}"/>
              </a:ext>
            </a:extLst>
          </p:cNvPr>
          <p:cNvSpPr/>
          <p:nvPr/>
        </p:nvSpPr>
        <p:spPr>
          <a:xfrm>
            <a:off x="6776302" y="3489817"/>
            <a:ext cx="1199334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Set CYSDV2</a:t>
            </a:r>
          </a:p>
        </p:txBody>
      </p:sp>
      <p:sp>
        <p:nvSpPr>
          <p:cNvPr id="79" name="Rectángulo: esquinas redondeadas 78">
            <a:extLst>
              <a:ext uri="{FF2B5EF4-FFF2-40B4-BE49-F238E27FC236}">
                <a16:creationId xmlns:a16="http://schemas.microsoft.com/office/drawing/2014/main" id="{12203941-5DDB-4F0B-A15D-54A9F2D5C1E6}"/>
              </a:ext>
            </a:extLst>
          </p:cNvPr>
          <p:cNvSpPr/>
          <p:nvPr/>
        </p:nvSpPr>
        <p:spPr>
          <a:xfrm>
            <a:off x="6776302" y="3899694"/>
            <a:ext cx="1199334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HRM </a:t>
            </a:r>
            <a:r>
              <a:rPr lang="es-ES" sz="1400" dirty="0" err="1">
                <a:solidFill>
                  <a:schemeClr val="tx1"/>
                </a:solidFill>
              </a:rPr>
              <a:t>markers</a:t>
            </a:r>
            <a:endParaRPr lang="es-ES" sz="1400" dirty="0">
              <a:solidFill>
                <a:schemeClr val="tx1"/>
              </a:solidFill>
            </a:endParaRPr>
          </a:p>
        </p:txBody>
      </p:sp>
      <p:cxnSp>
        <p:nvCxnSpPr>
          <p:cNvPr id="80" name="Conector recto de flecha 202">
            <a:extLst>
              <a:ext uri="{FF2B5EF4-FFF2-40B4-BE49-F238E27FC236}">
                <a16:creationId xmlns:a16="http://schemas.microsoft.com/office/drawing/2014/main" id="{83F4011D-AC66-468E-8AE9-6971DA2D3663}"/>
              </a:ext>
            </a:extLst>
          </p:cNvPr>
          <p:cNvCxnSpPr>
            <a:cxnSpLocks/>
          </p:cNvCxnSpPr>
          <p:nvPr/>
        </p:nvCxnSpPr>
        <p:spPr>
          <a:xfrm>
            <a:off x="3686946" y="3670977"/>
            <a:ext cx="1014189" cy="866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ángulo: esquinas redondeadas 64">
            <a:extLst>
              <a:ext uri="{FF2B5EF4-FFF2-40B4-BE49-F238E27FC236}">
                <a16:creationId xmlns:a16="http://schemas.microsoft.com/office/drawing/2014/main" id="{DA3FC789-2490-4E24-ABBD-D712C33EDC56}"/>
              </a:ext>
            </a:extLst>
          </p:cNvPr>
          <p:cNvSpPr/>
          <p:nvPr/>
        </p:nvSpPr>
        <p:spPr>
          <a:xfrm>
            <a:off x="4283968" y="4561745"/>
            <a:ext cx="1062969" cy="342826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solidFill>
                <a:schemeClr val="tx1"/>
              </a:solidFill>
            </a:endParaRPr>
          </a:p>
          <a:p>
            <a:pPr algn="ctr"/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4</a:t>
            </a:r>
            <a:r>
              <a:rPr lang="es-ES" dirty="0">
                <a:solidFill>
                  <a:schemeClr val="tx1"/>
                </a:solidFill>
              </a:rPr>
              <a:t>xPS</a:t>
            </a:r>
          </a:p>
          <a:p>
            <a:pPr algn="ctr"/>
            <a:endParaRPr lang="es-ES" baseline="-25000" dirty="0">
              <a:solidFill>
                <a:schemeClr val="tx1"/>
              </a:solidFill>
            </a:endParaRPr>
          </a:p>
        </p:txBody>
      </p:sp>
      <p:sp>
        <p:nvSpPr>
          <p:cNvPr id="82" name="45 Abrir llave">
            <a:extLst>
              <a:ext uri="{FF2B5EF4-FFF2-40B4-BE49-F238E27FC236}">
                <a16:creationId xmlns:a16="http://schemas.microsoft.com/office/drawing/2014/main" id="{323D253E-86A4-49D1-B7E8-232D384AD085}"/>
              </a:ext>
            </a:extLst>
          </p:cNvPr>
          <p:cNvSpPr/>
          <p:nvPr/>
        </p:nvSpPr>
        <p:spPr>
          <a:xfrm>
            <a:off x="6541460" y="4461977"/>
            <a:ext cx="246650" cy="541397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Rectángulo: esquinas redondeadas 82">
            <a:extLst>
              <a:ext uri="{FF2B5EF4-FFF2-40B4-BE49-F238E27FC236}">
                <a16:creationId xmlns:a16="http://schemas.microsoft.com/office/drawing/2014/main" id="{A343B6C4-9EB5-4495-BFA0-BE05369297DD}"/>
              </a:ext>
            </a:extLst>
          </p:cNvPr>
          <p:cNvSpPr/>
          <p:nvPr/>
        </p:nvSpPr>
        <p:spPr>
          <a:xfrm>
            <a:off x="6819433" y="4356446"/>
            <a:ext cx="1825872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Background</a:t>
            </a:r>
            <a:r>
              <a:rPr lang="es-ES" sz="1400" dirty="0">
                <a:solidFill>
                  <a:schemeClr val="tx1"/>
                </a:solidFill>
              </a:rPr>
              <a:t> </a:t>
            </a:r>
            <a:r>
              <a:rPr lang="es-ES" sz="1400" dirty="0" err="1">
                <a:solidFill>
                  <a:schemeClr val="tx1"/>
                </a:solidFill>
              </a:rPr>
              <a:t>markers</a:t>
            </a:r>
            <a:r>
              <a:rPr lang="es-ES" sz="1400" dirty="0">
                <a:solidFill>
                  <a:schemeClr val="tx1"/>
                </a:solidFill>
              </a:rPr>
              <a:t> 2</a:t>
            </a:r>
          </a:p>
        </p:txBody>
      </p:sp>
      <p:sp>
        <p:nvSpPr>
          <p:cNvPr id="84" name="Rectángulo: esquinas redondeadas 83">
            <a:extLst>
              <a:ext uri="{FF2B5EF4-FFF2-40B4-BE49-F238E27FC236}">
                <a16:creationId xmlns:a16="http://schemas.microsoft.com/office/drawing/2014/main" id="{B3C9D605-3988-4F06-9C4C-9E18947B0AA6}"/>
              </a:ext>
            </a:extLst>
          </p:cNvPr>
          <p:cNvSpPr/>
          <p:nvPr/>
        </p:nvSpPr>
        <p:spPr>
          <a:xfrm>
            <a:off x="6833759" y="4846869"/>
            <a:ext cx="1199334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HRM </a:t>
            </a:r>
            <a:r>
              <a:rPr lang="es-ES" sz="1400" dirty="0" err="1">
                <a:solidFill>
                  <a:schemeClr val="tx1"/>
                </a:solidFill>
              </a:rPr>
              <a:t>markers</a:t>
            </a:r>
            <a:endParaRPr lang="es-ES" sz="1400" dirty="0">
              <a:solidFill>
                <a:schemeClr val="tx1"/>
              </a:solidFill>
            </a:endParaRPr>
          </a:p>
        </p:txBody>
      </p:sp>
      <p:cxnSp>
        <p:nvCxnSpPr>
          <p:cNvPr id="86" name="Conector recto de flecha 202">
            <a:extLst>
              <a:ext uri="{FF2B5EF4-FFF2-40B4-BE49-F238E27FC236}">
                <a16:creationId xmlns:a16="http://schemas.microsoft.com/office/drawing/2014/main" id="{DAC8CB7F-F136-4BAC-94D6-E4DB8E0A9BBA}"/>
              </a:ext>
            </a:extLst>
          </p:cNvPr>
          <p:cNvCxnSpPr>
            <a:cxnSpLocks/>
          </p:cNvCxnSpPr>
          <p:nvPr/>
        </p:nvCxnSpPr>
        <p:spPr>
          <a:xfrm>
            <a:off x="2901367" y="5441056"/>
            <a:ext cx="0" cy="1208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Diagrama de flujo: unión de suma 210">
            <a:extLst>
              <a:ext uri="{FF2B5EF4-FFF2-40B4-BE49-F238E27FC236}">
                <a16:creationId xmlns:a16="http://schemas.microsoft.com/office/drawing/2014/main" id="{02840678-0E52-4BEA-9610-948B0F01D762}"/>
              </a:ext>
            </a:extLst>
          </p:cNvPr>
          <p:cNvSpPr/>
          <p:nvPr/>
        </p:nvSpPr>
        <p:spPr>
          <a:xfrm>
            <a:off x="4721497" y="5164439"/>
            <a:ext cx="245330" cy="253401"/>
          </a:xfrm>
          <a:prstGeom prst="flowChartSummingJunct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3" name="Rectángulo: esquinas redondeadas 68">
            <a:extLst>
              <a:ext uri="{FF2B5EF4-FFF2-40B4-BE49-F238E27FC236}">
                <a16:creationId xmlns:a16="http://schemas.microsoft.com/office/drawing/2014/main" id="{A9C8F47B-8693-419D-AEDF-CDB740F18336}"/>
              </a:ext>
            </a:extLst>
          </p:cNvPr>
          <p:cNvSpPr/>
          <p:nvPr/>
        </p:nvSpPr>
        <p:spPr>
          <a:xfrm>
            <a:off x="4355976" y="5794130"/>
            <a:ext cx="1296144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(BC</a:t>
            </a:r>
            <a:r>
              <a:rPr lang="es-ES" baseline="-25000" dirty="0">
                <a:solidFill>
                  <a:schemeClr val="tx1"/>
                </a:solidFill>
              </a:rPr>
              <a:t>4</a:t>
            </a:r>
            <a:r>
              <a:rPr lang="es-ES" dirty="0">
                <a:solidFill>
                  <a:schemeClr val="tx1"/>
                </a:solidFill>
              </a:rPr>
              <a:t>xPS)S</a:t>
            </a:r>
            <a:r>
              <a:rPr lang="es-ES" baseline="-25000" dirty="0">
                <a:solidFill>
                  <a:schemeClr val="tx1"/>
                </a:solidFill>
              </a:rPr>
              <a:t>1</a:t>
            </a:r>
          </a:p>
        </p:txBody>
      </p:sp>
      <p:cxnSp>
        <p:nvCxnSpPr>
          <p:cNvPr id="96" name="Conector recto de flecha 202">
            <a:extLst>
              <a:ext uri="{FF2B5EF4-FFF2-40B4-BE49-F238E27FC236}">
                <a16:creationId xmlns:a16="http://schemas.microsoft.com/office/drawing/2014/main" id="{5D0E9808-0826-47AF-8796-BF1152D226EA}"/>
              </a:ext>
            </a:extLst>
          </p:cNvPr>
          <p:cNvCxnSpPr>
            <a:cxnSpLocks/>
          </p:cNvCxnSpPr>
          <p:nvPr/>
        </p:nvCxnSpPr>
        <p:spPr>
          <a:xfrm flipH="1">
            <a:off x="4844162" y="5438106"/>
            <a:ext cx="9652" cy="3560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ángulo: esquinas redondeadas 71">
            <a:extLst>
              <a:ext uri="{FF2B5EF4-FFF2-40B4-BE49-F238E27FC236}">
                <a16:creationId xmlns:a16="http://schemas.microsoft.com/office/drawing/2014/main" id="{6082FD54-906A-4519-8D20-FD1845E0CC21}"/>
              </a:ext>
            </a:extLst>
          </p:cNvPr>
          <p:cNvSpPr/>
          <p:nvPr/>
        </p:nvSpPr>
        <p:spPr>
          <a:xfrm>
            <a:off x="5951542" y="5921896"/>
            <a:ext cx="2464871" cy="34379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 err="1">
                <a:solidFill>
                  <a:schemeClr val="tx1"/>
                </a:solidFill>
              </a:rPr>
              <a:t>Genotyping</a:t>
            </a:r>
            <a:r>
              <a:rPr lang="es-ES" sz="1400" dirty="0">
                <a:solidFill>
                  <a:schemeClr val="tx1"/>
                </a:solidFill>
              </a:rPr>
              <a:t> </a:t>
            </a:r>
            <a:r>
              <a:rPr lang="es-ES" sz="1400" dirty="0" err="1">
                <a:solidFill>
                  <a:schemeClr val="tx1"/>
                </a:solidFill>
              </a:rPr>
              <a:t>with</a:t>
            </a:r>
            <a:r>
              <a:rPr lang="es-ES" sz="1400" dirty="0">
                <a:solidFill>
                  <a:schemeClr val="tx1"/>
                </a:solidFill>
              </a:rPr>
              <a:t> HRM </a:t>
            </a:r>
            <a:r>
              <a:rPr lang="es-ES" sz="1400" dirty="0" err="1">
                <a:solidFill>
                  <a:schemeClr val="tx1"/>
                </a:solidFill>
              </a:rPr>
              <a:t>markers</a:t>
            </a:r>
            <a:endParaRPr lang="es-ES" sz="1400" dirty="0">
              <a:solidFill>
                <a:schemeClr val="tx1"/>
              </a:solidFill>
            </a:endParaRPr>
          </a:p>
        </p:txBody>
      </p:sp>
      <p:sp>
        <p:nvSpPr>
          <p:cNvPr id="98" name="CuadroTexto 218">
            <a:extLst>
              <a:ext uri="{FF2B5EF4-FFF2-40B4-BE49-F238E27FC236}">
                <a16:creationId xmlns:a16="http://schemas.microsoft.com/office/drawing/2014/main" id="{96821BB5-7A89-437B-9D0E-745759AFC0CB}"/>
              </a:ext>
            </a:extLst>
          </p:cNvPr>
          <p:cNvSpPr txBox="1"/>
          <p:nvPr/>
        </p:nvSpPr>
        <p:spPr>
          <a:xfrm>
            <a:off x="3362678" y="4886700"/>
            <a:ext cx="99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1 </a:t>
            </a:r>
            <a:r>
              <a:rPr lang="es-ES" sz="1200" b="1" dirty="0" err="1"/>
              <a:t>family</a:t>
            </a:r>
            <a:endParaRPr lang="es-ES" sz="1200" b="1" dirty="0"/>
          </a:p>
        </p:txBody>
      </p:sp>
      <p:sp>
        <p:nvSpPr>
          <p:cNvPr id="99" name="CuadroTexto 218">
            <a:extLst>
              <a:ext uri="{FF2B5EF4-FFF2-40B4-BE49-F238E27FC236}">
                <a16:creationId xmlns:a16="http://schemas.microsoft.com/office/drawing/2014/main" id="{7D352742-5EFE-43B4-90CE-0C21ED6F8DE8}"/>
              </a:ext>
            </a:extLst>
          </p:cNvPr>
          <p:cNvSpPr txBox="1"/>
          <p:nvPr/>
        </p:nvSpPr>
        <p:spPr>
          <a:xfrm>
            <a:off x="4416996" y="4877307"/>
            <a:ext cx="811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2 </a:t>
            </a:r>
            <a:r>
              <a:rPr lang="es-ES" sz="1200" b="1" dirty="0" err="1"/>
              <a:t>families</a:t>
            </a:r>
            <a:endParaRPr lang="es-ES" sz="1200" b="1" dirty="0"/>
          </a:p>
        </p:txBody>
      </p:sp>
      <p:sp>
        <p:nvSpPr>
          <p:cNvPr id="102" name="CuadroTexto 218">
            <a:extLst>
              <a:ext uri="{FF2B5EF4-FFF2-40B4-BE49-F238E27FC236}">
                <a16:creationId xmlns:a16="http://schemas.microsoft.com/office/drawing/2014/main" id="{5A74EA5B-D70C-4ADB-A759-AA65C46BF65D}"/>
              </a:ext>
            </a:extLst>
          </p:cNvPr>
          <p:cNvSpPr txBox="1"/>
          <p:nvPr/>
        </p:nvSpPr>
        <p:spPr>
          <a:xfrm>
            <a:off x="4491415" y="6076400"/>
            <a:ext cx="99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4 </a:t>
            </a:r>
            <a:r>
              <a:rPr lang="es-ES" sz="1200" b="1" dirty="0" err="1"/>
              <a:t>families</a:t>
            </a:r>
            <a:endParaRPr lang="es-ES" sz="1200" b="1" dirty="0"/>
          </a:p>
        </p:txBody>
      </p:sp>
      <p:sp>
        <p:nvSpPr>
          <p:cNvPr id="106" name="45 Abrir llave">
            <a:extLst>
              <a:ext uri="{FF2B5EF4-FFF2-40B4-BE49-F238E27FC236}">
                <a16:creationId xmlns:a16="http://schemas.microsoft.com/office/drawing/2014/main" id="{8590173A-EF39-4CE3-A470-2A4A39591580}"/>
              </a:ext>
            </a:extLst>
          </p:cNvPr>
          <p:cNvSpPr/>
          <p:nvPr/>
        </p:nvSpPr>
        <p:spPr>
          <a:xfrm rot="10800000">
            <a:off x="5653452" y="5538889"/>
            <a:ext cx="278786" cy="1256293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5" name="45 Abrir llave">
            <a:extLst>
              <a:ext uri="{FF2B5EF4-FFF2-40B4-BE49-F238E27FC236}">
                <a16:creationId xmlns:a16="http://schemas.microsoft.com/office/drawing/2014/main" id="{2A428423-3C89-4F07-BA09-8A6F1DA1B925}"/>
              </a:ext>
            </a:extLst>
          </p:cNvPr>
          <p:cNvSpPr/>
          <p:nvPr/>
        </p:nvSpPr>
        <p:spPr>
          <a:xfrm>
            <a:off x="6867305" y="400978"/>
            <a:ext cx="211837" cy="423960"/>
          </a:xfrm>
          <a:prstGeom prst="leftBrace">
            <a:avLst>
              <a:gd name="adj1" fmla="val 8333"/>
              <a:gd name="adj2" fmla="val 51308"/>
            </a:avLst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5" name="Rectángulo: esquinas redondeadas 71">
            <a:extLst>
              <a:ext uri="{FF2B5EF4-FFF2-40B4-BE49-F238E27FC236}">
                <a16:creationId xmlns:a16="http://schemas.microsoft.com/office/drawing/2014/main" id="{7833987B-4AEE-4951-A7B5-8CD1440228D1}"/>
              </a:ext>
            </a:extLst>
          </p:cNvPr>
          <p:cNvSpPr/>
          <p:nvPr/>
        </p:nvSpPr>
        <p:spPr>
          <a:xfrm>
            <a:off x="7171640" y="457437"/>
            <a:ext cx="568712" cy="351891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GBS</a:t>
            </a:r>
          </a:p>
        </p:txBody>
      </p:sp>
      <p:sp>
        <p:nvSpPr>
          <p:cNvPr id="88" name="Rectángulo: esquinas redondeadas 87">
            <a:extLst>
              <a:ext uri="{FF2B5EF4-FFF2-40B4-BE49-F238E27FC236}">
                <a16:creationId xmlns:a16="http://schemas.microsoft.com/office/drawing/2014/main" id="{49E6E2D2-D86F-4964-860D-C5E8D8BF4EDB}"/>
              </a:ext>
            </a:extLst>
          </p:cNvPr>
          <p:cNvSpPr/>
          <p:nvPr/>
        </p:nvSpPr>
        <p:spPr>
          <a:xfrm>
            <a:off x="6109272" y="2789749"/>
            <a:ext cx="1825872" cy="24883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dirty="0">
                <a:solidFill>
                  <a:schemeClr val="tx1"/>
                </a:solidFill>
              </a:rPr>
              <a:t>Set WMV2</a:t>
            </a:r>
          </a:p>
        </p:txBody>
      </p:sp>
      <p:sp>
        <p:nvSpPr>
          <p:cNvPr id="89" name="Diagrama de flujo: unión de suma 210">
            <a:extLst>
              <a:ext uri="{FF2B5EF4-FFF2-40B4-BE49-F238E27FC236}">
                <a16:creationId xmlns:a16="http://schemas.microsoft.com/office/drawing/2014/main" id="{CFA4F4DB-CAF5-4695-86E2-56D7C965580A}"/>
              </a:ext>
            </a:extLst>
          </p:cNvPr>
          <p:cNvSpPr/>
          <p:nvPr/>
        </p:nvSpPr>
        <p:spPr>
          <a:xfrm>
            <a:off x="2778702" y="5961498"/>
            <a:ext cx="245330" cy="253401"/>
          </a:xfrm>
          <a:prstGeom prst="flowChartSummingJunct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90" name="Conector recto de flecha 202">
            <a:extLst>
              <a:ext uri="{FF2B5EF4-FFF2-40B4-BE49-F238E27FC236}">
                <a16:creationId xmlns:a16="http://schemas.microsoft.com/office/drawing/2014/main" id="{F0FAA84F-B47B-4D12-BD59-B5069BA3BBD6}"/>
              </a:ext>
            </a:extLst>
          </p:cNvPr>
          <p:cNvCxnSpPr>
            <a:cxnSpLocks/>
          </p:cNvCxnSpPr>
          <p:nvPr/>
        </p:nvCxnSpPr>
        <p:spPr>
          <a:xfrm>
            <a:off x="2903251" y="6272746"/>
            <a:ext cx="0" cy="1208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Rectángulo: esquinas redondeadas 68">
            <a:extLst>
              <a:ext uri="{FF2B5EF4-FFF2-40B4-BE49-F238E27FC236}">
                <a16:creationId xmlns:a16="http://schemas.microsoft.com/office/drawing/2014/main" id="{1E8AB4CD-45F5-40E3-98AF-3A6582ED512D}"/>
              </a:ext>
            </a:extLst>
          </p:cNvPr>
          <p:cNvSpPr/>
          <p:nvPr/>
        </p:nvSpPr>
        <p:spPr>
          <a:xfrm>
            <a:off x="2486509" y="6451393"/>
            <a:ext cx="835197" cy="34379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dirty="0">
                <a:solidFill>
                  <a:schemeClr val="tx1"/>
                </a:solidFill>
              </a:rPr>
              <a:t>BC</a:t>
            </a:r>
            <a:r>
              <a:rPr lang="es-ES" baseline="-25000" dirty="0">
                <a:solidFill>
                  <a:schemeClr val="tx1"/>
                </a:solidFill>
              </a:rPr>
              <a:t>5</a:t>
            </a:r>
            <a:r>
              <a:rPr lang="es-ES" dirty="0">
                <a:solidFill>
                  <a:schemeClr val="tx1"/>
                </a:solidFill>
              </a:rPr>
              <a:t>S</a:t>
            </a:r>
            <a:r>
              <a:rPr lang="es-ES" baseline="-25000" dirty="0">
                <a:solidFill>
                  <a:schemeClr val="tx1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6991089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9231124A0E269745BEE266AF9FE30367" ma:contentTypeVersion="10" ma:contentTypeDescription="Crear nuevo documento." ma:contentTypeScope="" ma:versionID="3e3cb83fc9ccc732bfa30f424d38312e">
  <xsd:schema xmlns:xsd="http://www.w3.org/2001/XMLSchema" xmlns:xs="http://www.w3.org/2001/XMLSchema" xmlns:p="http://schemas.microsoft.com/office/2006/metadata/properties" xmlns:ns3="93139b8e-db01-456c-9cff-14e272819d6a" targetNamespace="http://schemas.microsoft.com/office/2006/metadata/properties" ma:root="true" ma:fieldsID="8a09e383610e00b350c0ff586b581e6e" ns3:_="">
    <xsd:import namespace="93139b8e-db01-456c-9cff-14e272819d6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3139b8e-db01-456c-9cff-14e272819d6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D39E52E-7EF6-4CA9-96AD-64C47461488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3139b8e-db01-456c-9cff-14e272819d6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687107A-DB4D-4D32-989C-4B42EC0EC0E3}">
  <ds:schemaRefs>
    <ds:schemaRef ds:uri="http://schemas.microsoft.com/office/infopath/2007/PartnerControls"/>
    <ds:schemaRef ds:uri="http://www.w3.org/XML/1998/namespace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http://schemas.microsoft.com/office/2006/metadata/properties"/>
    <ds:schemaRef ds:uri="93139b8e-db01-456c-9cff-14e272819d6a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B4A57640-0C42-424B-9D69-C447343204C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09</TotalTime>
  <Words>88</Words>
  <Application>Microsoft Office PowerPoint</Application>
  <PresentationFormat>Presentación en pantalla (4:3)</PresentationFormat>
  <Paragraphs>5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lant material generated and methodology used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 Gómez-Guillamón</dc:creator>
  <cp:lastModifiedBy>María López </cp:lastModifiedBy>
  <cp:revision>17</cp:revision>
  <dcterms:created xsi:type="dcterms:W3CDTF">2021-11-04T09:54:28Z</dcterms:created>
  <dcterms:modified xsi:type="dcterms:W3CDTF">2022-10-05T16:20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231124A0E269745BEE266AF9FE30367</vt:lpwstr>
  </property>
</Properties>
</file>